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5960"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2"/>
  </p:normalViewPr>
  <p:slideViewPr>
    <p:cSldViewPr snapToGrid="0">
      <p:cViewPr varScale="1">
        <p:scale>
          <a:sx n="79" d="100"/>
          <a:sy n="79" d="100"/>
        </p:scale>
        <p:origin x="2680" y="21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B0D8923-5C29-A040-BCF4-136B17F3305A}" type="datetimeFigureOut">
              <a:rPr lang="en-US" smtClean="0"/>
              <a:t>1/21/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B1563E1-3F1D-E64E-9CAD-2CF8F37E3708}" type="slidenum">
              <a:rPr lang="en-US" smtClean="0"/>
              <a:t>‹#›</a:t>
            </a:fld>
            <a:endParaRPr lang="en-US"/>
          </a:p>
        </p:txBody>
      </p:sp>
    </p:spTree>
    <p:extLst>
      <p:ext uri="{BB962C8B-B14F-4D97-AF65-F5344CB8AC3E}">
        <p14:creationId xmlns:p14="http://schemas.microsoft.com/office/powerpoint/2010/main" val="19635697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8672931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32891507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957411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7030163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4653425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4EE51A4-5CD0-874C-99AC-F783733B957E}" type="datetimeFigureOut">
              <a:rPr lang="en-US" smtClean="0"/>
              <a:t>1/2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9611415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4EE51A4-5CD0-874C-99AC-F783733B957E}" type="datetimeFigureOut">
              <a:rPr lang="en-US" smtClean="0"/>
              <a:t>1/21/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7231831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4EE51A4-5CD0-874C-99AC-F783733B957E}" type="datetimeFigureOut">
              <a:rPr lang="en-US" smtClean="0"/>
              <a:t>1/21/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27380578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EE51A4-5CD0-874C-99AC-F783733B957E}" type="datetimeFigureOut">
              <a:rPr lang="en-US" smtClean="0"/>
              <a:t>1/21/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22290950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4EE51A4-5CD0-874C-99AC-F783733B957E}" type="datetimeFigureOut">
              <a:rPr lang="en-US" smtClean="0"/>
              <a:t>1/2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8047035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4EE51A4-5CD0-874C-99AC-F783733B957E}" type="datetimeFigureOut">
              <a:rPr lang="en-US" smtClean="0"/>
              <a:t>1/2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20069406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B4EE51A4-5CD0-874C-99AC-F783733B957E}" type="datetimeFigureOut">
              <a:rPr lang="en-US" smtClean="0"/>
              <a:t>1/21/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649317A-20A4-A641-8123-AC75D9543818}" type="slidenum">
              <a:rPr lang="en-US" smtClean="0"/>
              <a:t>‹#›</a:t>
            </a:fld>
            <a:endParaRPr lang="en-US"/>
          </a:p>
        </p:txBody>
      </p:sp>
    </p:spTree>
    <p:extLst>
      <p:ext uri="{BB962C8B-B14F-4D97-AF65-F5344CB8AC3E}">
        <p14:creationId xmlns:p14="http://schemas.microsoft.com/office/powerpoint/2010/main" val="178093913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microsoft.com/office/2007/relationships/hdphoto" Target="../media/hdphoto5.wdp"/><Relationship Id="rId18" Type="http://schemas.openxmlformats.org/officeDocument/2006/relationships/image" Target="../media/image10.png"/><Relationship Id="rId3" Type="http://schemas.openxmlformats.org/officeDocument/2006/relationships/image" Target="../media/image2.png"/><Relationship Id="rId21" Type="http://schemas.microsoft.com/office/2007/relationships/hdphoto" Target="../media/hdphoto9.wdp"/><Relationship Id="rId7" Type="http://schemas.openxmlformats.org/officeDocument/2006/relationships/image" Target="../media/image4.png"/><Relationship Id="rId12" Type="http://schemas.openxmlformats.org/officeDocument/2006/relationships/image" Target="../media/image7.png"/><Relationship Id="rId17" Type="http://schemas.microsoft.com/office/2007/relationships/hdphoto" Target="../media/hdphoto7.wdp"/><Relationship Id="rId2" Type="http://schemas.openxmlformats.org/officeDocument/2006/relationships/image" Target="../media/image1.emf"/><Relationship Id="rId16" Type="http://schemas.openxmlformats.org/officeDocument/2006/relationships/image" Target="../media/image9.png"/><Relationship Id="rId20" Type="http://schemas.openxmlformats.org/officeDocument/2006/relationships/image" Target="../media/image11.png"/><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6.png"/><Relationship Id="rId5" Type="http://schemas.openxmlformats.org/officeDocument/2006/relationships/image" Target="../media/image3.png"/><Relationship Id="rId15" Type="http://schemas.microsoft.com/office/2007/relationships/hdphoto" Target="../media/hdphoto6.wdp"/><Relationship Id="rId10" Type="http://schemas.microsoft.com/office/2007/relationships/hdphoto" Target="../media/hdphoto4.wdp"/><Relationship Id="rId19" Type="http://schemas.microsoft.com/office/2007/relationships/hdphoto" Target="../media/hdphoto8.wdp"/><Relationship Id="rId4" Type="http://schemas.microsoft.com/office/2007/relationships/hdphoto" Target="../media/hdphoto1.wdp"/><Relationship Id="rId9" Type="http://schemas.openxmlformats.org/officeDocument/2006/relationships/image" Target="../media/image5.png"/><Relationship Id="rId14" Type="http://schemas.openxmlformats.org/officeDocument/2006/relationships/image" Target="../media/image8.png"/><Relationship Id="rId22"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0324A6CA-FC8E-0E2B-6CAA-0F301B7EC6A6}"/>
              </a:ext>
            </a:extLst>
          </p:cNvPr>
          <p:cNvGrpSpPr/>
          <p:nvPr/>
        </p:nvGrpSpPr>
        <p:grpSpPr>
          <a:xfrm>
            <a:off x="4013420" y="3656366"/>
            <a:ext cx="1941453" cy="411094"/>
            <a:chOff x="3640818" y="3115780"/>
            <a:chExt cx="1812022" cy="383688"/>
          </a:xfrm>
        </p:grpSpPr>
        <p:pic>
          <p:nvPicPr>
            <p:cNvPr id="20" name="Picture 19">
              <a:extLst>
                <a:ext uri="{FF2B5EF4-FFF2-40B4-BE49-F238E27FC236}">
                  <a16:creationId xmlns:a16="http://schemas.microsoft.com/office/drawing/2014/main" id="{1D2C0D0B-BB93-4F7C-8672-A195E605E861}"/>
                </a:ext>
              </a:extLst>
            </p:cNvPr>
            <p:cNvPicPr>
              <a:picLocks noChangeAspect="1"/>
            </p:cNvPicPr>
            <p:nvPr/>
          </p:nvPicPr>
          <p:blipFill rotWithShape="1">
            <a:blip r:embed="rId2"/>
            <a:srcRect l="22467" t="83754" r="65111" b="12429"/>
            <a:stretch/>
          </p:blipFill>
          <p:spPr>
            <a:xfrm>
              <a:off x="3640818" y="3223687"/>
              <a:ext cx="793951" cy="275781"/>
            </a:xfrm>
            <a:prstGeom prst="rect">
              <a:avLst/>
            </a:prstGeom>
          </p:spPr>
        </p:pic>
        <p:grpSp>
          <p:nvGrpSpPr>
            <p:cNvPr id="8" name="Group 7">
              <a:extLst>
                <a:ext uri="{FF2B5EF4-FFF2-40B4-BE49-F238E27FC236}">
                  <a16:creationId xmlns:a16="http://schemas.microsoft.com/office/drawing/2014/main" id="{14725D52-3D4B-F93B-5FC9-1E1AE1AD9E9A}"/>
                </a:ext>
              </a:extLst>
            </p:cNvPr>
            <p:cNvGrpSpPr/>
            <p:nvPr/>
          </p:nvGrpSpPr>
          <p:grpSpPr>
            <a:xfrm>
              <a:off x="4571976" y="3115780"/>
              <a:ext cx="880864" cy="330206"/>
              <a:chOff x="4383442" y="3115780"/>
              <a:chExt cx="880864" cy="330206"/>
            </a:xfrm>
          </p:grpSpPr>
          <p:pic>
            <p:nvPicPr>
              <p:cNvPr id="22" name="Picture 21">
                <a:extLst>
                  <a:ext uri="{FF2B5EF4-FFF2-40B4-BE49-F238E27FC236}">
                    <a16:creationId xmlns:a16="http://schemas.microsoft.com/office/drawing/2014/main" id="{93AF49B0-0E80-4C07-9218-FEF5ECC62F6E}"/>
                  </a:ext>
                </a:extLst>
              </p:cNvPr>
              <p:cNvPicPr>
                <a:picLocks noChangeAspect="1"/>
              </p:cNvPicPr>
              <p:nvPr/>
            </p:nvPicPr>
            <p:blipFill rotWithShape="1">
              <a:blip r:embed="rId2"/>
              <a:srcRect l="22467" t="80098" r="73793" b="16084"/>
              <a:stretch/>
            </p:blipFill>
            <p:spPr>
              <a:xfrm>
                <a:off x="4383442" y="3115780"/>
                <a:ext cx="239004" cy="275782"/>
              </a:xfrm>
              <a:prstGeom prst="rect">
                <a:avLst/>
              </a:prstGeom>
            </p:spPr>
          </p:pic>
          <p:sp>
            <p:nvSpPr>
              <p:cNvPr id="23" name="TextBox 22">
                <a:extLst>
                  <a:ext uri="{FF2B5EF4-FFF2-40B4-BE49-F238E27FC236}">
                    <a16:creationId xmlns:a16="http://schemas.microsoft.com/office/drawing/2014/main" id="{6E16E077-0119-4A86-B2A9-36FEE09CE4A8}"/>
                  </a:ext>
                </a:extLst>
              </p:cNvPr>
              <p:cNvSpPr txBox="1"/>
              <p:nvPr/>
            </p:nvSpPr>
            <p:spPr>
              <a:xfrm>
                <a:off x="4508458" y="3198226"/>
                <a:ext cx="755848" cy="247760"/>
              </a:xfrm>
              <a:prstGeom prst="rect">
                <a:avLst/>
              </a:prstGeom>
              <a:noFill/>
            </p:spPr>
            <p:txBody>
              <a:bodyPr wrap="none" rtlCol="0">
                <a:spAutoFit/>
              </a:bodyPr>
              <a:lstStyle/>
              <a:p>
                <a:r>
                  <a:rPr lang="en-US" sz="1125" dirty="0">
                    <a:latin typeface="Arial" panose="020B0604020202020204" pitchFamily="34" charset="0"/>
                    <a:cs typeface="Arial" panose="020B0604020202020204" pitchFamily="34" charset="0"/>
                  </a:rPr>
                  <a:t>CAD Med</a:t>
                </a:r>
              </a:p>
            </p:txBody>
          </p:sp>
        </p:grpSp>
      </p:grpSp>
      <p:sp>
        <p:nvSpPr>
          <p:cNvPr id="24" name="TextBox 23">
            <a:extLst>
              <a:ext uri="{FF2B5EF4-FFF2-40B4-BE49-F238E27FC236}">
                <a16:creationId xmlns:a16="http://schemas.microsoft.com/office/drawing/2014/main" id="{EB93F5F4-6838-49F0-8026-36DC5C3C97FC}"/>
              </a:ext>
            </a:extLst>
          </p:cNvPr>
          <p:cNvSpPr txBox="1"/>
          <p:nvPr/>
        </p:nvSpPr>
        <p:spPr>
          <a:xfrm>
            <a:off x="423589" y="1050973"/>
            <a:ext cx="1116909" cy="323165"/>
          </a:xfrm>
          <a:prstGeom prst="rect">
            <a:avLst/>
          </a:prstGeom>
          <a:noFill/>
        </p:spPr>
        <p:txBody>
          <a:bodyPr wrap="none" rtlCol="0">
            <a:spAutoFit/>
          </a:bodyPr>
          <a:lstStyle/>
          <a:p>
            <a:r>
              <a:rPr lang="en-US" sz="1500" b="1" dirty="0">
                <a:solidFill>
                  <a:srgbClr val="FF0000"/>
                </a:solidFill>
                <a:latin typeface="Arial" panose="020B0604020202020204" pitchFamily="34" charset="0"/>
                <a:cs typeface="Arial" panose="020B0604020202020204" pitchFamily="34" charset="0"/>
              </a:rPr>
              <a:t>OA Medial</a:t>
            </a:r>
          </a:p>
        </p:txBody>
      </p:sp>
      <p:sp>
        <p:nvSpPr>
          <p:cNvPr id="43" name="TextBox 42">
            <a:extLst>
              <a:ext uri="{FF2B5EF4-FFF2-40B4-BE49-F238E27FC236}">
                <a16:creationId xmlns:a16="http://schemas.microsoft.com/office/drawing/2014/main" id="{0ED6D3D4-612F-4A65-A8A8-B2794DE1D956}"/>
              </a:ext>
            </a:extLst>
          </p:cNvPr>
          <p:cNvSpPr txBox="1"/>
          <p:nvPr/>
        </p:nvSpPr>
        <p:spPr>
          <a:xfrm>
            <a:off x="1797468" y="1049504"/>
            <a:ext cx="1253869" cy="323165"/>
          </a:xfrm>
          <a:prstGeom prst="rect">
            <a:avLst/>
          </a:prstGeom>
          <a:noFill/>
        </p:spPr>
        <p:txBody>
          <a:bodyPr wrap="none" rtlCol="0">
            <a:spAutoFit/>
          </a:bodyPr>
          <a:lstStyle/>
          <a:p>
            <a:r>
              <a:rPr lang="en-US" sz="1500" b="1" dirty="0">
                <a:solidFill>
                  <a:srgbClr val="1818FF"/>
                </a:solidFill>
                <a:latin typeface="Arial" panose="020B0604020202020204" pitchFamily="34" charset="0"/>
                <a:cs typeface="Arial" panose="020B0604020202020204" pitchFamily="34" charset="0"/>
              </a:rPr>
              <a:t>CAD Medial</a:t>
            </a:r>
          </a:p>
        </p:txBody>
      </p:sp>
      <p:sp>
        <p:nvSpPr>
          <p:cNvPr id="93" name="TextBox 92">
            <a:extLst>
              <a:ext uri="{FF2B5EF4-FFF2-40B4-BE49-F238E27FC236}">
                <a16:creationId xmlns:a16="http://schemas.microsoft.com/office/drawing/2014/main" id="{4C7312DD-1650-4FAA-B7FB-2672C2FC1DB1}"/>
              </a:ext>
            </a:extLst>
          </p:cNvPr>
          <p:cNvSpPr txBox="1"/>
          <p:nvPr/>
        </p:nvSpPr>
        <p:spPr>
          <a:xfrm>
            <a:off x="254319" y="642307"/>
            <a:ext cx="3121928" cy="488082"/>
          </a:xfrm>
          <a:prstGeom prst="rect">
            <a:avLst/>
          </a:prstGeom>
          <a:noFill/>
        </p:spPr>
        <p:txBody>
          <a:bodyPr wrap="square" rtlCol="0">
            <a:spAutoFit/>
          </a:bodyPr>
          <a:lstStyle/>
          <a:p>
            <a:r>
              <a:rPr lang="en-US" sz="1286" b="1" dirty="0">
                <a:latin typeface="Arial" panose="020B0604020202020204" pitchFamily="34" charset="0"/>
                <a:cs typeface="Arial" panose="020B0604020202020204" pitchFamily="34" charset="0"/>
              </a:rPr>
              <a:t>A – ROI Selection for Site Matched                     	Subchondral Bone</a:t>
            </a:r>
          </a:p>
        </p:txBody>
      </p:sp>
      <p:sp>
        <p:nvSpPr>
          <p:cNvPr id="95" name="Rectangle 94">
            <a:extLst>
              <a:ext uri="{FF2B5EF4-FFF2-40B4-BE49-F238E27FC236}">
                <a16:creationId xmlns:a16="http://schemas.microsoft.com/office/drawing/2014/main" id="{0CA41C29-0C08-4E0D-B518-B0ED5A3B8D18}"/>
              </a:ext>
            </a:extLst>
          </p:cNvPr>
          <p:cNvSpPr/>
          <p:nvPr/>
        </p:nvSpPr>
        <p:spPr>
          <a:xfrm>
            <a:off x="3329876" y="642306"/>
            <a:ext cx="3755856" cy="290208"/>
          </a:xfrm>
          <a:prstGeom prst="rect">
            <a:avLst/>
          </a:prstGeom>
        </p:spPr>
        <p:txBody>
          <a:bodyPr wrap="square">
            <a:spAutoFit/>
          </a:bodyPr>
          <a:lstStyle/>
          <a:p>
            <a:r>
              <a:rPr lang="en-US" sz="1286" b="1" dirty="0">
                <a:latin typeface="Arial" panose="020B0604020202020204" pitchFamily="34" charset="0"/>
                <a:cs typeface="Arial" panose="020B0604020202020204" pitchFamily="34" charset="0"/>
              </a:rPr>
              <a:t>B – PLS-DA OA Med vs Cad Med</a:t>
            </a:r>
          </a:p>
        </p:txBody>
      </p:sp>
      <p:sp>
        <p:nvSpPr>
          <p:cNvPr id="106" name="TextBox 105">
            <a:extLst>
              <a:ext uri="{FF2B5EF4-FFF2-40B4-BE49-F238E27FC236}">
                <a16:creationId xmlns:a16="http://schemas.microsoft.com/office/drawing/2014/main" id="{C16D978B-756A-4307-B2A1-85CFA50C2C83}"/>
              </a:ext>
            </a:extLst>
          </p:cNvPr>
          <p:cNvSpPr txBox="1"/>
          <p:nvPr/>
        </p:nvSpPr>
        <p:spPr>
          <a:xfrm>
            <a:off x="157672" y="4135058"/>
            <a:ext cx="6321310" cy="1815882"/>
          </a:xfrm>
          <a:prstGeom prst="rect">
            <a:avLst/>
          </a:prstGeom>
          <a:noFill/>
        </p:spPr>
        <p:txBody>
          <a:bodyPr wrap="square" rtlCol="0">
            <a:spAutoFit/>
          </a:bodyPr>
          <a:lstStyle/>
          <a:p>
            <a:pPr algn="just"/>
            <a:r>
              <a:rPr lang="en-US" sz="1400" b="1" dirty="0">
                <a:latin typeface="Arial" panose="020B0604020202020204" pitchFamily="34" charset="0"/>
                <a:ea typeface="Times New Roman" panose="02020603050405020304" pitchFamily="18" charset="0"/>
                <a:cs typeface="Arial" panose="020B0604020202020204" pitchFamily="34" charset="0"/>
              </a:rPr>
              <a:t>OA Medial vs Cadaveric Medial Comparison. </a:t>
            </a:r>
            <a:r>
              <a:rPr lang="en-US" sz="1400" dirty="0">
                <a:latin typeface="Arial" panose="020B0604020202020204" pitchFamily="34" charset="0"/>
                <a:ea typeface="Times New Roman" panose="02020603050405020304" pitchFamily="18" charset="0"/>
                <a:cs typeface="Arial" panose="020B0604020202020204" pitchFamily="34" charset="0"/>
              </a:rPr>
              <a:t>(A) Site-matched comparison of arthritic OA medial tibial plateaus to age and BMI matched </a:t>
            </a:r>
            <a:r>
              <a:rPr lang="en-US" sz="1400" kern="0" dirty="0">
                <a:latin typeface="Arial" panose="020B0604020202020204" pitchFamily="34" charset="0"/>
                <a:ea typeface="Times New Roman" panose="02020603050405020304" pitchFamily="18" charset="0"/>
              </a:rPr>
              <a:t>non-arthritic</a:t>
            </a:r>
            <a:r>
              <a:rPr lang="en-US" sz="1400" dirty="0">
                <a:latin typeface="Arial" panose="020B0604020202020204" pitchFamily="34" charset="0"/>
                <a:ea typeface="Times New Roman" panose="02020603050405020304" pitchFamily="18" charset="0"/>
                <a:cs typeface="Arial" panose="020B0604020202020204" pitchFamily="34" charset="0"/>
              </a:rPr>
              <a:t> cadaveric tibial plateaus. Outlined blue areas showed the identified cartilage tissue in OA and Cadaveric tissue used to delineate the subchondral bone regions of interest (ROI) (Green) used for quantitative analysis. (B) Three-dimensional PLS-DA of candidate feature intensity from the segmented ROIs confirmed group separation in multiple component dimensions. </a:t>
            </a:r>
          </a:p>
          <a:p>
            <a:pPr algn="just"/>
            <a:r>
              <a:rPr lang="en-US" sz="1400" dirty="0">
                <a:latin typeface="Arial" panose="020B0604020202020204" pitchFamily="34" charset="0"/>
                <a:cs typeface="Arial" panose="020B0604020202020204" pitchFamily="34" charset="0"/>
              </a:rPr>
              <a:t> </a:t>
            </a:r>
          </a:p>
        </p:txBody>
      </p:sp>
      <p:grpSp>
        <p:nvGrpSpPr>
          <p:cNvPr id="45" name="Group 44">
            <a:extLst>
              <a:ext uri="{FF2B5EF4-FFF2-40B4-BE49-F238E27FC236}">
                <a16:creationId xmlns:a16="http://schemas.microsoft.com/office/drawing/2014/main" id="{60585022-F5EA-5F3D-7E0D-9CA07544E2ED}"/>
              </a:ext>
            </a:extLst>
          </p:cNvPr>
          <p:cNvGrpSpPr/>
          <p:nvPr/>
        </p:nvGrpSpPr>
        <p:grpSpPr>
          <a:xfrm>
            <a:off x="254318" y="1426737"/>
            <a:ext cx="3234241" cy="2448962"/>
            <a:chOff x="132325" y="1034793"/>
            <a:chExt cx="2714446" cy="2055374"/>
          </a:xfrm>
        </p:grpSpPr>
        <p:grpSp>
          <p:nvGrpSpPr>
            <p:cNvPr id="100" name="Group 99">
              <a:extLst>
                <a:ext uri="{FF2B5EF4-FFF2-40B4-BE49-F238E27FC236}">
                  <a16:creationId xmlns:a16="http://schemas.microsoft.com/office/drawing/2014/main" id="{65167B28-7648-40AC-9866-51B7CB689E67}"/>
                </a:ext>
              </a:extLst>
            </p:cNvPr>
            <p:cNvGrpSpPr/>
            <p:nvPr/>
          </p:nvGrpSpPr>
          <p:grpSpPr>
            <a:xfrm>
              <a:off x="380615" y="1101080"/>
              <a:ext cx="1128189" cy="1902038"/>
              <a:chOff x="160731" y="1438637"/>
              <a:chExt cx="1128189" cy="1902038"/>
            </a:xfrm>
          </p:grpSpPr>
          <p:pic>
            <p:nvPicPr>
              <p:cNvPr id="62" name="Picture 61">
                <a:extLst>
                  <a:ext uri="{FF2B5EF4-FFF2-40B4-BE49-F238E27FC236}">
                    <a16:creationId xmlns:a16="http://schemas.microsoft.com/office/drawing/2014/main" id="{2FD4B258-CA71-46DC-B641-E450EFE864CA}"/>
                  </a:ext>
                </a:extLst>
              </p:cNvPr>
              <p:cNvPicPr>
                <a:picLocks noChangeAspect="1"/>
              </p:cNvPicPr>
              <p:nvPr/>
            </p:nvPicPr>
            <p:blipFill rotWithShape="1">
              <a:blip r:embed="rId3">
                <a:extLst>
                  <a:ext uri="{BEBA8EAE-BF5A-486C-A8C5-ECC9F3942E4B}">
                    <a14:imgProps xmlns:a14="http://schemas.microsoft.com/office/drawing/2010/main">
                      <a14:imgLayer r:embed="rId4">
                        <a14:imgEffect>
                          <a14:backgroundRemoval t="61508" b="95635" l="2978" r="47270">
                            <a14:foregroundMark x1="4591" y1="77976" x2="4591" y2="74603"/>
                            <a14:foregroundMark x1="8561" y1="61508" x2="15385" y2="62103"/>
                            <a14:foregroundMark x1="2978" y1="65675" x2="2978" y2="65675"/>
                            <a14:foregroundMark x1="41563" y1="82540" x2="46526" y2="82341"/>
                            <a14:foregroundMark x1="47022" y1="82937" x2="47270" y2="80754"/>
                            <a14:foregroundMark x1="46526" y1="79960" x2="47022" y2="80754"/>
                          </a14:backgroundRemoval>
                        </a14:imgEffect>
                      </a14:imgLayer>
                    </a14:imgProps>
                  </a:ext>
                </a:extLst>
              </a:blip>
              <a:srcRect t="57331" r="51517"/>
              <a:stretch/>
            </p:blipFill>
            <p:spPr>
              <a:xfrm>
                <a:off x="193187" y="1828773"/>
                <a:ext cx="1095733" cy="636883"/>
              </a:xfrm>
              <a:prstGeom prst="rect">
                <a:avLst/>
              </a:prstGeom>
            </p:spPr>
          </p:pic>
          <p:pic>
            <p:nvPicPr>
              <p:cNvPr id="63" name="Picture 62">
                <a:extLst>
                  <a:ext uri="{FF2B5EF4-FFF2-40B4-BE49-F238E27FC236}">
                    <a16:creationId xmlns:a16="http://schemas.microsoft.com/office/drawing/2014/main" id="{885CF3D4-4BCE-4B23-A609-E5B819477AFF}"/>
                  </a:ext>
                </a:extLst>
              </p:cNvPr>
              <p:cNvPicPr>
                <a:picLocks noChangeAspect="1"/>
              </p:cNvPicPr>
              <p:nvPr/>
            </p:nvPicPr>
            <p:blipFill rotWithShape="1">
              <a:blip r:embed="rId5">
                <a:extLst>
                  <a:ext uri="{BEBA8EAE-BF5A-486C-A8C5-ECC9F3942E4B}">
                    <a14:imgProps xmlns:a14="http://schemas.microsoft.com/office/drawing/2010/main">
                      <a14:imgLayer r:embed="rId6">
                        <a14:imgEffect>
                          <a14:backgroundRemoval t="58929" b="95635" l="1985" r="51241">
                            <a14:foregroundMark x1="5955" y1="84127" x2="4342" y2="65675"/>
                            <a14:foregroundMark x1="2357" y1="62897" x2="2730" y2="74802"/>
                            <a14:foregroundMark x1="4715" y1="60714" x2="15012" y2="58929"/>
                            <a14:foregroundMark x1="45285" y1="79960" x2="50124" y2="79563"/>
                            <a14:foregroundMark x1="50000" y1="79960" x2="51241" y2="75992"/>
                            <a14:foregroundMark x1="50993" y1="79563" x2="51241" y2="80357"/>
                          </a14:backgroundRemoval>
                        </a14:imgEffect>
                      </a14:imgLayer>
                    </a14:imgProps>
                  </a:ext>
                </a:extLst>
              </a:blip>
              <a:srcRect t="57331" r="47769"/>
              <a:stretch/>
            </p:blipFill>
            <p:spPr>
              <a:xfrm>
                <a:off x="205670" y="1438637"/>
                <a:ext cx="989642" cy="533946"/>
              </a:xfrm>
              <a:prstGeom prst="rect">
                <a:avLst/>
              </a:prstGeom>
            </p:spPr>
          </p:pic>
          <p:pic>
            <p:nvPicPr>
              <p:cNvPr id="64" name="Picture 63">
                <a:extLst>
                  <a:ext uri="{FF2B5EF4-FFF2-40B4-BE49-F238E27FC236}">
                    <a16:creationId xmlns:a16="http://schemas.microsoft.com/office/drawing/2014/main" id="{D54E44C6-5445-463F-801C-0A8FD17A5820}"/>
                  </a:ext>
                </a:extLst>
              </p:cNvPr>
              <p:cNvPicPr>
                <a:picLocks noChangeAspect="1"/>
              </p:cNvPicPr>
              <p:nvPr/>
            </p:nvPicPr>
            <p:blipFill rotWithShape="1">
              <a:blip r:embed="rId7">
                <a:extLst>
                  <a:ext uri="{BEBA8EAE-BF5A-486C-A8C5-ECC9F3942E4B}">
                    <a14:imgProps xmlns:a14="http://schemas.microsoft.com/office/drawing/2010/main">
                      <a14:imgLayer r:embed="rId8">
                        <a14:imgEffect>
                          <a14:backgroundRemoval t="58929" b="95437" l="5087" r="61042">
                            <a14:foregroundMark x1="6824" y1="73016" x2="5087" y2="69643"/>
                            <a14:foregroundMark x1="9429" y1="59722" x2="13151" y2="58929"/>
                            <a14:foregroundMark x1="34739" y1="79960" x2="59057" y2="84325"/>
                            <a14:foregroundMark x1="59553" y1="82341" x2="60298" y2="87897"/>
                            <a14:foregroundMark x1="61042" y1="84921" x2="60546" y2="81349"/>
                            <a14:foregroundMark x1="60298" y1="88492" x2="60298" y2="88492"/>
                            <a14:foregroundMark x1="60794" y1="88889" x2="59801" y2="88294"/>
                          </a14:backgroundRemoval>
                        </a14:imgEffect>
                      </a14:imgLayer>
                    </a14:imgProps>
                  </a:ext>
                </a:extLst>
              </a:blip>
              <a:srcRect t="54989" r="38133"/>
              <a:stretch/>
            </p:blipFill>
            <p:spPr>
              <a:xfrm>
                <a:off x="160731" y="2308356"/>
                <a:ext cx="1128189" cy="542096"/>
              </a:xfrm>
              <a:prstGeom prst="rect">
                <a:avLst/>
              </a:prstGeom>
            </p:spPr>
          </p:pic>
          <p:sp>
            <p:nvSpPr>
              <p:cNvPr id="67" name="Freeform 70">
                <a:extLst>
                  <a:ext uri="{FF2B5EF4-FFF2-40B4-BE49-F238E27FC236}">
                    <a16:creationId xmlns:a16="http://schemas.microsoft.com/office/drawing/2014/main" id="{DA0E59FF-45C1-4351-B6D2-368966F6B622}"/>
                  </a:ext>
                </a:extLst>
              </p:cNvPr>
              <p:cNvSpPr/>
              <p:nvPr/>
            </p:nvSpPr>
            <p:spPr>
              <a:xfrm>
                <a:off x="826421" y="1618089"/>
                <a:ext cx="355182" cy="196395"/>
              </a:xfrm>
              <a:custGeom>
                <a:avLst/>
                <a:gdLst>
                  <a:gd name="connsiteX0" fmla="*/ 18814 w 639703"/>
                  <a:gd name="connsiteY0" fmla="*/ 0 h 353718"/>
                  <a:gd name="connsiteX1" fmla="*/ 0 w 639703"/>
                  <a:gd name="connsiteY1" fmla="*/ 353718 h 353718"/>
                  <a:gd name="connsiteX2" fmla="*/ 240829 w 639703"/>
                  <a:gd name="connsiteY2" fmla="*/ 319852 h 353718"/>
                  <a:gd name="connsiteX3" fmla="*/ 575733 w 639703"/>
                  <a:gd name="connsiteY3" fmla="*/ 267170 h 353718"/>
                  <a:gd name="connsiteX4" fmla="*/ 639703 w 639703"/>
                  <a:gd name="connsiteY4" fmla="*/ 195674 h 353718"/>
                  <a:gd name="connsiteX5" fmla="*/ 628414 w 639703"/>
                  <a:gd name="connsiteY5" fmla="*/ 150518 h 353718"/>
                  <a:gd name="connsiteX6" fmla="*/ 579496 w 639703"/>
                  <a:gd name="connsiteY6" fmla="*/ 67733 h 353718"/>
                  <a:gd name="connsiteX7" fmla="*/ 515526 w 639703"/>
                  <a:gd name="connsiteY7" fmla="*/ 52681 h 353718"/>
                  <a:gd name="connsiteX8" fmla="*/ 293511 w 639703"/>
                  <a:gd name="connsiteY8" fmla="*/ 33867 h 353718"/>
                  <a:gd name="connsiteX9" fmla="*/ 79022 w 639703"/>
                  <a:gd name="connsiteY9" fmla="*/ 7526 h 353718"/>
                  <a:gd name="connsiteX10" fmla="*/ 18814 w 639703"/>
                  <a:gd name="connsiteY10" fmla="*/ 0 h 3537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639703" h="353718">
                    <a:moveTo>
                      <a:pt x="18814" y="0"/>
                    </a:moveTo>
                    <a:lnTo>
                      <a:pt x="0" y="353718"/>
                    </a:lnTo>
                    <a:lnTo>
                      <a:pt x="240829" y="319852"/>
                    </a:lnTo>
                    <a:lnTo>
                      <a:pt x="575733" y="267170"/>
                    </a:lnTo>
                    <a:lnTo>
                      <a:pt x="639703" y="195674"/>
                    </a:lnTo>
                    <a:lnTo>
                      <a:pt x="628414" y="150518"/>
                    </a:lnTo>
                    <a:lnTo>
                      <a:pt x="579496" y="67733"/>
                    </a:lnTo>
                    <a:lnTo>
                      <a:pt x="515526" y="52681"/>
                    </a:lnTo>
                    <a:lnTo>
                      <a:pt x="293511" y="33867"/>
                    </a:lnTo>
                    <a:lnTo>
                      <a:pt x="79022" y="7526"/>
                    </a:lnTo>
                    <a:lnTo>
                      <a:pt x="18814" y="0"/>
                    </a:lnTo>
                    <a:close/>
                  </a:path>
                </a:pathLst>
              </a:custGeom>
              <a:noFill/>
              <a:ln w="12700">
                <a:solidFill>
                  <a:srgbClr val="90E90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929" dirty="0"/>
              </a:p>
            </p:txBody>
          </p:sp>
          <p:sp>
            <p:nvSpPr>
              <p:cNvPr id="68" name="Freeform 71">
                <a:extLst>
                  <a:ext uri="{FF2B5EF4-FFF2-40B4-BE49-F238E27FC236}">
                    <a16:creationId xmlns:a16="http://schemas.microsoft.com/office/drawing/2014/main" id="{E3B091C6-450F-4B56-9E29-81DAAE17D84A}"/>
                  </a:ext>
                </a:extLst>
              </p:cNvPr>
              <p:cNvSpPr/>
              <p:nvPr/>
            </p:nvSpPr>
            <p:spPr>
              <a:xfrm>
                <a:off x="774188" y="2106988"/>
                <a:ext cx="488899" cy="194306"/>
              </a:xfrm>
              <a:custGeom>
                <a:avLst/>
                <a:gdLst>
                  <a:gd name="connsiteX0" fmla="*/ 48918 w 880533"/>
                  <a:gd name="connsiteY0" fmla="*/ 0 h 349956"/>
                  <a:gd name="connsiteX1" fmla="*/ 0 w 880533"/>
                  <a:gd name="connsiteY1" fmla="*/ 349956 h 349956"/>
                  <a:gd name="connsiteX2" fmla="*/ 222014 w 880533"/>
                  <a:gd name="connsiteY2" fmla="*/ 342430 h 349956"/>
                  <a:gd name="connsiteX3" fmla="*/ 767644 w 880533"/>
                  <a:gd name="connsiteY3" fmla="*/ 233304 h 349956"/>
                  <a:gd name="connsiteX4" fmla="*/ 876770 w 880533"/>
                  <a:gd name="connsiteY4" fmla="*/ 222015 h 349956"/>
                  <a:gd name="connsiteX5" fmla="*/ 880533 w 880533"/>
                  <a:gd name="connsiteY5" fmla="*/ 154282 h 349956"/>
                  <a:gd name="connsiteX6" fmla="*/ 831614 w 880533"/>
                  <a:gd name="connsiteY6" fmla="*/ 82785 h 349956"/>
                  <a:gd name="connsiteX7" fmla="*/ 571970 w 880533"/>
                  <a:gd name="connsiteY7" fmla="*/ 30104 h 349956"/>
                  <a:gd name="connsiteX8" fmla="*/ 225777 w 880533"/>
                  <a:gd name="connsiteY8" fmla="*/ 48919 h 349956"/>
                  <a:gd name="connsiteX9" fmla="*/ 48918 w 880533"/>
                  <a:gd name="connsiteY9" fmla="*/ 0 h 34995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880533" h="349956">
                    <a:moveTo>
                      <a:pt x="48918" y="0"/>
                    </a:moveTo>
                    <a:lnTo>
                      <a:pt x="0" y="349956"/>
                    </a:lnTo>
                    <a:lnTo>
                      <a:pt x="222014" y="342430"/>
                    </a:lnTo>
                    <a:lnTo>
                      <a:pt x="767644" y="233304"/>
                    </a:lnTo>
                    <a:lnTo>
                      <a:pt x="876770" y="222015"/>
                    </a:lnTo>
                    <a:lnTo>
                      <a:pt x="880533" y="154282"/>
                    </a:lnTo>
                    <a:lnTo>
                      <a:pt x="831614" y="82785"/>
                    </a:lnTo>
                    <a:lnTo>
                      <a:pt x="571970" y="30104"/>
                    </a:lnTo>
                    <a:lnTo>
                      <a:pt x="225777" y="48919"/>
                    </a:lnTo>
                    <a:lnTo>
                      <a:pt x="48918" y="0"/>
                    </a:lnTo>
                    <a:close/>
                  </a:path>
                </a:pathLst>
              </a:custGeom>
              <a:noFill/>
              <a:ln w="12700">
                <a:solidFill>
                  <a:srgbClr val="90E90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929" dirty="0"/>
              </a:p>
            </p:txBody>
          </p:sp>
          <p:sp>
            <p:nvSpPr>
              <p:cNvPr id="69" name="Freeform 72">
                <a:extLst>
                  <a:ext uri="{FF2B5EF4-FFF2-40B4-BE49-F238E27FC236}">
                    <a16:creationId xmlns:a16="http://schemas.microsoft.com/office/drawing/2014/main" id="{F71419B6-C035-444E-867E-DC31D09A904A}"/>
                  </a:ext>
                </a:extLst>
              </p:cNvPr>
              <p:cNvSpPr/>
              <p:nvPr/>
            </p:nvSpPr>
            <p:spPr>
              <a:xfrm>
                <a:off x="826421" y="2558279"/>
                <a:ext cx="447112" cy="171323"/>
              </a:xfrm>
              <a:custGeom>
                <a:avLst/>
                <a:gdLst>
                  <a:gd name="connsiteX0" fmla="*/ 26340 w 805274"/>
                  <a:gd name="connsiteY0" fmla="*/ 0 h 308563"/>
                  <a:gd name="connsiteX1" fmla="*/ 0 w 805274"/>
                  <a:gd name="connsiteY1" fmla="*/ 308563 h 308563"/>
                  <a:gd name="connsiteX2" fmla="*/ 771407 w 805274"/>
                  <a:gd name="connsiteY2" fmla="*/ 301037 h 308563"/>
                  <a:gd name="connsiteX3" fmla="*/ 790222 w 805274"/>
                  <a:gd name="connsiteY3" fmla="*/ 274697 h 308563"/>
                  <a:gd name="connsiteX4" fmla="*/ 805274 w 805274"/>
                  <a:gd name="connsiteY4" fmla="*/ 237067 h 308563"/>
                  <a:gd name="connsiteX5" fmla="*/ 786459 w 805274"/>
                  <a:gd name="connsiteY5" fmla="*/ 184385 h 308563"/>
                  <a:gd name="connsiteX6" fmla="*/ 767644 w 805274"/>
                  <a:gd name="connsiteY6" fmla="*/ 150519 h 308563"/>
                  <a:gd name="connsiteX7" fmla="*/ 741303 w 805274"/>
                  <a:gd name="connsiteY7" fmla="*/ 150519 h 308563"/>
                  <a:gd name="connsiteX8" fmla="*/ 714963 w 805274"/>
                  <a:gd name="connsiteY8" fmla="*/ 109126 h 308563"/>
                  <a:gd name="connsiteX9" fmla="*/ 699911 w 805274"/>
                  <a:gd name="connsiteY9" fmla="*/ 101600 h 308563"/>
                  <a:gd name="connsiteX10" fmla="*/ 406400 w 805274"/>
                  <a:gd name="connsiteY10" fmla="*/ 56445 h 308563"/>
                  <a:gd name="connsiteX11" fmla="*/ 191911 w 805274"/>
                  <a:gd name="connsiteY11" fmla="*/ 30104 h 308563"/>
                  <a:gd name="connsiteX12" fmla="*/ 26340 w 805274"/>
                  <a:gd name="connsiteY12" fmla="*/ 0 h 3085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805274" h="308563">
                    <a:moveTo>
                      <a:pt x="26340" y="0"/>
                    </a:moveTo>
                    <a:lnTo>
                      <a:pt x="0" y="308563"/>
                    </a:lnTo>
                    <a:lnTo>
                      <a:pt x="771407" y="301037"/>
                    </a:lnTo>
                    <a:lnTo>
                      <a:pt x="790222" y="274697"/>
                    </a:lnTo>
                    <a:lnTo>
                      <a:pt x="805274" y="237067"/>
                    </a:lnTo>
                    <a:lnTo>
                      <a:pt x="786459" y="184385"/>
                    </a:lnTo>
                    <a:lnTo>
                      <a:pt x="767644" y="150519"/>
                    </a:lnTo>
                    <a:lnTo>
                      <a:pt x="741303" y="150519"/>
                    </a:lnTo>
                    <a:lnTo>
                      <a:pt x="714963" y="109126"/>
                    </a:lnTo>
                    <a:lnTo>
                      <a:pt x="699911" y="101600"/>
                    </a:lnTo>
                    <a:lnTo>
                      <a:pt x="406400" y="56445"/>
                    </a:lnTo>
                    <a:lnTo>
                      <a:pt x="191911" y="30104"/>
                    </a:lnTo>
                    <a:lnTo>
                      <a:pt x="26340" y="0"/>
                    </a:lnTo>
                    <a:close/>
                  </a:path>
                </a:pathLst>
              </a:custGeom>
              <a:noFill/>
              <a:ln w="12700">
                <a:solidFill>
                  <a:srgbClr val="90E90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929" dirty="0"/>
              </a:p>
            </p:txBody>
          </p:sp>
          <p:pic>
            <p:nvPicPr>
              <p:cNvPr id="65" name="Picture 64">
                <a:extLst>
                  <a:ext uri="{FF2B5EF4-FFF2-40B4-BE49-F238E27FC236}">
                    <a16:creationId xmlns:a16="http://schemas.microsoft.com/office/drawing/2014/main" id="{4E3EEFCB-4D11-40C6-B1D2-FBE04E704575}"/>
                  </a:ext>
                </a:extLst>
              </p:cNvPr>
              <p:cNvPicPr>
                <a:picLocks noChangeAspect="1"/>
              </p:cNvPicPr>
              <p:nvPr/>
            </p:nvPicPr>
            <p:blipFill rotWithShape="1">
              <a:blip r:embed="rId9">
                <a:extLst>
                  <a:ext uri="{BEBA8EAE-BF5A-486C-A8C5-ECC9F3942E4B}">
                    <a14:imgProps xmlns:a14="http://schemas.microsoft.com/office/drawing/2010/main">
                      <a14:imgLayer r:embed="rId10">
                        <a14:imgEffect>
                          <a14:backgroundRemoval t="53770" b="94643" l="3722" r="57320">
                            <a14:foregroundMark x1="4218" y1="83532" x2="4467" y2="66667"/>
                            <a14:foregroundMark x1="9801" y1="53968" x2="13400" y2="53968"/>
                            <a14:foregroundMark x1="52854" y1="83135" x2="57444" y2="80556"/>
                            <a14:foregroundMark x1="3722" y1="81944" x2="4094" y2="69048"/>
                            <a14:foregroundMark x1="33375" y1="88095" x2="38586" y2="86905"/>
                          </a14:backgroundRemoval>
                        </a14:imgEffect>
                      </a14:imgLayer>
                    </a14:imgProps>
                  </a:ext>
                </a:extLst>
              </a:blip>
              <a:srcRect t="49991" r="42014"/>
              <a:stretch/>
            </p:blipFill>
            <p:spPr>
              <a:xfrm>
                <a:off x="184896" y="2754584"/>
                <a:ext cx="1028990" cy="586091"/>
              </a:xfrm>
              <a:prstGeom prst="rect">
                <a:avLst/>
              </a:prstGeom>
              <a:ln w="19050">
                <a:noFill/>
              </a:ln>
            </p:spPr>
          </p:pic>
          <p:sp>
            <p:nvSpPr>
              <p:cNvPr id="70" name="Freeform 73">
                <a:extLst>
                  <a:ext uri="{FF2B5EF4-FFF2-40B4-BE49-F238E27FC236}">
                    <a16:creationId xmlns:a16="http://schemas.microsoft.com/office/drawing/2014/main" id="{500327F2-521D-4478-A36F-48A3F7277D96}"/>
                  </a:ext>
                </a:extLst>
              </p:cNvPr>
              <p:cNvSpPr/>
              <p:nvPr/>
            </p:nvSpPr>
            <p:spPr>
              <a:xfrm>
                <a:off x="600775" y="3061329"/>
                <a:ext cx="580828" cy="135805"/>
              </a:xfrm>
              <a:custGeom>
                <a:avLst/>
                <a:gdLst>
                  <a:gd name="connsiteX0" fmla="*/ 94074 w 1046103"/>
                  <a:gd name="connsiteY0" fmla="*/ 0 h 244593"/>
                  <a:gd name="connsiteX1" fmla="*/ 0 w 1046103"/>
                  <a:gd name="connsiteY1" fmla="*/ 233304 h 244593"/>
                  <a:gd name="connsiteX2" fmla="*/ 368770 w 1046103"/>
                  <a:gd name="connsiteY2" fmla="*/ 244593 h 244593"/>
                  <a:gd name="connsiteX3" fmla="*/ 425214 w 1046103"/>
                  <a:gd name="connsiteY3" fmla="*/ 233304 h 244593"/>
                  <a:gd name="connsiteX4" fmla="*/ 560681 w 1046103"/>
                  <a:gd name="connsiteY4" fmla="*/ 191911 h 244593"/>
                  <a:gd name="connsiteX5" fmla="*/ 692385 w 1046103"/>
                  <a:gd name="connsiteY5" fmla="*/ 184385 h 244593"/>
                  <a:gd name="connsiteX6" fmla="*/ 756355 w 1046103"/>
                  <a:gd name="connsiteY6" fmla="*/ 188148 h 244593"/>
                  <a:gd name="connsiteX7" fmla="*/ 797748 w 1046103"/>
                  <a:gd name="connsiteY7" fmla="*/ 184385 h 244593"/>
                  <a:gd name="connsiteX8" fmla="*/ 842903 w 1046103"/>
                  <a:gd name="connsiteY8" fmla="*/ 169334 h 244593"/>
                  <a:gd name="connsiteX9" fmla="*/ 1042340 w 1046103"/>
                  <a:gd name="connsiteY9" fmla="*/ 165571 h 244593"/>
                  <a:gd name="connsiteX10" fmla="*/ 1046103 w 1046103"/>
                  <a:gd name="connsiteY10" fmla="*/ 120415 h 244593"/>
                  <a:gd name="connsiteX11" fmla="*/ 1042340 w 1046103"/>
                  <a:gd name="connsiteY11" fmla="*/ 75260 h 244593"/>
                  <a:gd name="connsiteX12" fmla="*/ 1008474 w 1046103"/>
                  <a:gd name="connsiteY12" fmla="*/ 37630 h 244593"/>
                  <a:gd name="connsiteX13" fmla="*/ 880533 w 1046103"/>
                  <a:gd name="connsiteY13" fmla="*/ 105363 h 244593"/>
                  <a:gd name="connsiteX14" fmla="*/ 854192 w 1046103"/>
                  <a:gd name="connsiteY14" fmla="*/ 135467 h 244593"/>
                  <a:gd name="connsiteX15" fmla="*/ 805274 w 1046103"/>
                  <a:gd name="connsiteY15" fmla="*/ 124178 h 244593"/>
                  <a:gd name="connsiteX16" fmla="*/ 760118 w 1046103"/>
                  <a:gd name="connsiteY16" fmla="*/ 139230 h 244593"/>
                  <a:gd name="connsiteX17" fmla="*/ 658518 w 1046103"/>
                  <a:gd name="connsiteY17" fmla="*/ 127941 h 244593"/>
                  <a:gd name="connsiteX18" fmla="*/ 538103 w 1046103"/>
                  <a:gd name="connsiteY18" fmla="*/ 135467 h 244593"/>
                  <a:gd name="connsiteX19" fmla="*/ 413926 w 1046103"/>
                  <a:gd name="connsiteY19" fmla="*/ 135467 h 244593"/>
                  <a:gd name="connsiteX20" fmla="*/ 357481 w 1046103"/>
                  <a:gd name="connsiteY20" fmla="*/ 135467 h 244593"/>
                  <a:gd name="connsiteX21" fmla="*/ 94074 w 1046103"/>
                  <a:gd name="connsiteY21" fmla="*/ 0 h 24459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6103" h="244593">
                    <a:moveTo>
                      <a:pt x="94074" y="0"/>
                    </a:moveTo>
                    <a:lnTo>
                      <a:pt x="0" y="233304"/>
                    </a:lnTo>
                    <a:lnTo>
                      <a:pt x="368770" y="244593"/>
                    </a:lnTo>
                    <a:lnTo>
                      <a:pt x="425214" y="233304"/>
                    </a:lnTo>
                    <a:lnTo>
                      <a:pt x="560681" y="191911"/>
                    </a:lnTo>
                    <a:lnTo>
                      <a:pt x="692385" y="184385"/>
                    </a:lnTo>
                    <a:lnTo>
                      <a:pt x="756355" y="188148"/>
                    </a:lnTo>
                    <a:lnTo>
                      <a:pt x="797748" y="184385"/>
                    </a:lnTo>
                    <a:lnTo>
                      <a:pt x="842903" y="169334"/>
                    </a:lnTo>
                    <a:lnTo>
                      <a:pt x="1042340" y="165571"/>
                    </a:lnTo>
                    <a:lnTo>
                      <a:pt x="1046103" y="120415"/>
                    </a:lnTo>
                    <a:lnTo>
                      <a:pt x="1042340" y="75260"/>
                    </a:lnTo>
                    <a:lnTo>
                      <a:pt x="1008474" y="37630"/>
                    </a:lnTo>
                    <a:lnTo>
                      <a:pt x="880533" y="105363"/>
                    </a:lnTo>
                    <a:lnTo>
                      <a:pt x="854192" y="135467"/>
                    </a:lnTo>
                    <a:lnTo>
                      <a:pt x="805274" y="124178"/>
                    </a:lnTo>
                    <a:lnTo>
                      <a:pt x="760118" y="139230"/>
                    </a:lnTo>
                    <a:lnTo>
                      <a:pt x="658518" y="127941"/>
                    </a:lnTo>
                    <a:lnTo>
                      <a:pt x="538103" y="135467"/>
                    </a:lnTo>
                    <a:lnTo>
                      <a:pt x="413926" y="135467"/>
                    </a:lnTo>
                    <a:lnTo>
                      <a:pt x="357481" y="135467"/>
                    </a:lnTo>
                    <a:lnTo>
                      <a:pt x="94074" y="0"/>
                    </a:lnTo>
                    <a:close/>
                  </a:path>
                </a:pathLst>
              </a:custGeom>
              <a:noFill/>
              <a:ln w="12700">
                <a:solidFill>
                  <a:srgbClr val="90E90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929" dirty="0"/>
              </a:p>
            </p:txBody>
          </p:sp>
        </p:grpSp>
        <p:pic>
          <p:nvPicPr>
            <p:cNvPr id="66" name="Picture 65">
              <a:extLst>
                <a:ext uri="{FF2B5EF4-FFF2-40B4-BE49-F238E27FC236}">
                  <a16:creationId xmlns:a16="http://schemas.microsoft.com/office/drawing/2014/main" id="{8F9D8A04-2577-4496-9E67-A9D0F7EEBE67}"/>
                </a:ext>
              </a:extLst>
            </p:cNvPr>
            <p:cNvPicPr>
              <a:picLocks noChangeAspect="1"/>
            </p:cNvPicPr>
            <p:nvPr/>
          </p:nvPicPr>
          <p:blipFill rotWithShape="1">
            <a:blip r:embed="rId11"/>
            <a:srcRect t="89605" r="83080"/>
            <a:stretch/>
          </p:blipFill>
          <p:spPr>
            <a:xfrm>
              <a:off x="440302" y="2891638"/>
              <a:ext cx="320815" cy="130167"/>
            </a:xfrm>
            <a:prstGeom prst="rect">
              <a:avLst/>
            </a:prstGeom>
          </p:spPr>
        </p:pic>
        <p:sp>
          <p:nvSpPr>
            <p:cNvPr id="96" name="TextBox 95">
              <a:extLst>
                <a:ext uri="{FF2B5EF4-FFF2-40B4-BE49-F238E27FC236}">
                  <a16:creationId xmlns:a16="http://schemas.microsoft.com/office/drawing/2014/main" id="{54DFFADD-A419-4327-B239-91C368E5A822}"/>
                </a:ext>
              </a:extLst>
            </p:cNvPr>
            <p:cNvSpPr txBox="1"/>
            <p:nvPr/>
          </p:nvSpPr>
          <p:spPr>
            <a:xfrm>
              <a:off x="132325" y="1113570"/>
              <a:ext cx="324504" cy="243567"/>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P1</a:t>
              </a:r>
            </a:p>
          </p:txBody>
        </p:sp>
        <p:sp>
          <p:nvSpPr>
            <p:cNvPr id="97" name="TextBox 96">
              <a:extLst>
                <a:ext uri="{FF2B5EF4-FFF2-40B4-BE49-F238E27FC236}">
                  <a16:creationId xmlns:a16="http://schemas.microsoft.com/office/drawing/2014/main" id="{87C01F2B-4146-4797-9242-76C1E400923F}"/>
                </a:ext>
              </a:extLst>
            </p:cNvPr>
            <p:cNvSpPr txBox="1"/>
            <p:nvPr/>
          </p:nvSpPr>
          <p:spPr>
            <a:xfrm>
              <a:off x="132325" y="1598466"/>
              <a:ext cx="324504" cy="243567"/>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P2</a:t>
              </a:r>
            </a:p>
          </p:txBody>
        </p:sp>
        <p:sp>
          <p:nvSpPr>
            <p:cNvPr id="98" name="TextBox 97">
              <a:extLst>
                <a:ext uri="{FF2B5EF4-FFF2-40B4-BE49-F238E27FC236}">
                  <a16:creationId xmlns:a16="http://schemas.microsoft.com/office/drawing/2014/main" id="{92DD4372-08DC-44CD-BD9D-942374BAB98B}"/>
                </a:ext>
              </a:extLst>
            </p:cNvPr>
            <p:cNvSpPr txBox="1"/>
            <p:nvPr/>
          </p:nvSpPr>
          <p:spPr>
            <a:xfrm>
              <a:off x="132325" y="2083362"/>
              <a:ext cx="324504" cy="243567"/>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P3</a:t>
              </a:r>
            </a:p>
          </p:txBody>
        </p:sp>
        <p:sp>
          <p:nvSpPr>
            <p:cNvPr id="99" name="TextBox 98">
              <a:extLst>
                <a:ext uri="{FF2B5EF4-FFF2-40B4-BE49-F238E27FC236}">
                  <a16:creationId xmlns:a16="http://schemas.microsoft.com/office/drawing/2014/main" id="{2924D866-2144-4847-9B83-746A7C2B23F5}"/>
                </a:ext>
              </a:extLst>
            </p:cNvPr>
            <p:cNvSpPr txBox="1"/>
            <p:nvPr/>
          </p:nvSpPr>
          <p:spPr>
            <a:xfrm>
              <a:off x="132325" y="2568257"/>
              <a:ext cx="324504" cy="243567"/>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P4</a:t>
              </a:r>
            </a:p>
          </p:txBody>
        </p:sp>
        <p:grpSp>
          <p:nvGrpSpPr>
            <p:cNvPr id="44" name="Group 43">
              <a:extLst>
                <a:ext uri="{FF2B5EF4-FFF2-40B4-BE49-F238E27FC236}">
                  <a16:creationId xmlns:a16="http://schemas.microsoft.com/office/drawing/2014/main" id="{A4009566-88AD-B15F-4AFF-C1B0F2832A36}"/>
                </a:ext>
              </a:extLst>
            </p:cNvPr>
            <p:cNvGrpSpPr/>
            <p:nvPr/>
          </p:nvGrpSpPr>
          <p:grpSpPr>
            <a:xfrm>
              <a:off x="1408923" y="1034793"/>
              <a:ext cx="1437848" cy="2055374"/>
              <a:chOff x="1408923" y="1034793"/>
              <a:chExt cx="1437848" cy="2055374"/>
            </a:xfrm>
          </p:grpSpPr>
          <p:pic>
            <p:nvPicPr>
              <p:cNvPr id="39" name="Picture 38">
                <a:extLst>
                  <a:ext uri="{FF2B5EF4-FFF2-40B4-BE49-F238E27FC236}">
                    <a16:creationId xmlns:a16="http://schemas.microsoft.com/office/drawing/2014/main" id="{975A4A41-9B7A-40FA-9D90-442C9B74F930}"/>
                  </a:ext>
                </a:extLst>
              </p:cNvPr>
              <p:cNvPicPr>
                <a:picLocks noChangeAspect="1"/>
              </p:cNvPicPr>
              <p:nvPr/>
            </p:nvPicPr>
            <p:blipFill rotWithShape="1">
              <a:blip r:embed="rId12">
                <a:extLst>
                  <a:ext uri="{BEBA8EAE-BF5A-486C-A8C5-ECC9F3942E4B}">
                    <a14:imgProps xmlns:a14="http://schemas.microsoft.com/office/drawing/2010/main">
                      <a14:imgLayer r:embed="rId13">
                        <a14:imgEffect>
                          <a14:backgroundRemoval t="49409" b="94291" l="4512" r="42081">
                            <a14:foregroundMark x1="41989" y1="63189" x2="42081" y2="72638"/>
                          </a14:backgroundRemoval>
                        </a14:imgEffect>
                      </a14:imgLayer>
                    </a14:imgProps>
                  </a:ext>
                </a:extLst>
              </a:blip>
              <a:srcRect t="43925" r="54401"/>
              <a:stretch/>
            </p:blipFill>
            <p:spPr>
              <a:xfrm flipH="1">
                <a:off x="1657777" y="1905489"/>
                <a:ext cx="1188994" cy="683960"/>
              </a:xfrm>
              <a:prstGeom prst="rect">
                <a:avLst/>
              </a:prstGeom>
            </p:spPr>
          </p:pic>
          <p:pic>
            <p:nvPicPr>
              <p:cNvPr id="38" name="Picture 37">
                <a:extLst>
                  <a:ext uri="{FF2B5EF4-FFF2-40B4-BE49-F238E27FC236}">
                    <a16:creationId xmlns:a16="http://schemas.microsoft.com/office/drawing/2014/main" id="{31531971-C5FE-451F-99B7-A2B49D550ED6}"/>
                  </a:ext>
                </a:extLst>
              </p:cNvPr>
              <p:cNvPicPr>
                <a:picLocks noChangeAspect="1"/>
              </p:cNvPicPr>
              <p:nvPr/>
            </p:nvPicPr>
            <p:blipFill rotWithShape="1">
              <a:blip r:embed="rId14">
                <a:extLst>
                  <a:ext uri="{BEBA8EAE-BF5A-486C-A8C5-ECC9F3942E4B}">
                    <a14:imgProps xmlns:a14="http://schemas.microsoft.com/office/drawing/2010/main">
                      <a14:imgLayer r:embed="rId15">
                        <a14:imgEffect>
                          <a14:backgroundRemoval t="50000" b="94882" l="4052" r="41252">
                            <a14:foregroundMark x1="12615" y1="56299" x2="12891" y2="50000"/>
                            <a14:foregroundMark x1="35635" y1="72244" x2="40608" y2="82087"/>
                            <a14:foregroundMark x1="40792" y1="78150" x2="41252" y2="78150"/>
                          </a14:backgroundRemoval>
                        </a14:imgEffect>
                      </a14:imgLayer>
                    </a14:imgProps>
                  </a:ext>
                </a:extLst>
              </a:blip>
              <a:srcRect t="50000" r="58764"/>
              <a:stretch/>
            </p:blipFill>
            <p:spPr>
              <a:xfrm>
                <a:off x="1408923" y="1034793"/>
                <a:ext cx="1211754" cy="687298"/>
              </a:xfrm>
              <a:prstGeom prst="rect">
                <a:avLst/>
              </a:prstGeom>
            </p:spPr>
          </p:pic>
          <p:pic>
            <p:nvPicPr>
              <p:cNvPr id="41" name="Picture 40">
                <a:extLst>
                  <a:ext uri="{FF2B5EF4-FFF2-40B4-BE49-F238E27FC236}">
                    <a16:creationId xmlns:a16="http://schemas.microsoft.com/office/drawing/2014/main" id="{402D860A-31CF-4A4D-A560-B4611FE0108F}"/>
                  </a:ext>
                </a:extLst>
              </p:cNvPr>
              <p:cNvPicPr>
                <a:picLocks noChangeAspect="1"/>
              </p:cNvPicPr>
              <p:nvPr/>
            </p:nvPicPr>
            <p:blipFill rotWithShape="1">
              <a:blip r:embed="rId16">
                <a:extLst>
                  <a:ext uri="{BEBA8EAE-BF5A-486C-A8C5-ECC9F3942E4B}">
                    <a14:imgProps xmlns:a14="http://schemas.microsoft.com/office/drawing/2010/main">
                      <a14:imgLayer r:embed="rId17">
                        <a14:imgEffect>
                          <a14:backgroundRemoval t="50000" b="94291" l="4420" r="43462">
                            <a14:foregroundMark x1="9576" y1="50984" x2="16575" y2="50000"/>
                            <a14:foregroundMark x1="39042" y1="75000" x2="43462" y2="72835"/>
                            <a14:foregroundMark x1="9392" y1="62795" x2="9392" y2="62795"/>
                          </a14:backgroundRemoval>
                        </a14:imgEffect>
                      </a14:imgLayer>
                    </a14:imgProps>
                  </a:ext>
                </a:extLst>
              </a:blip>
              <a:srcRect t="46134" r="55664"/>
              <a:stretch/>
            </p:blipFill>
            <p:spPr>
              <a:xfrm>
                <a:off x="1495864" y="2386513"/>
                <a:ext cx="1238127" cy="703654"/>
              </a:xfrm>
              <a:prstGeom prst="rect">
                <a:avLst/>
              </a:prstGeom>
            </p:spPr>
          </p:pic>
          <p:sp>
            <p:nvSpPr>
              <p:cNvPr id="27" name="Freeform: Shape 26">
                <a:extLst>
                  <a:ext uri="{FF2B5EF4-FFF2-40B4-BE49-F238E27FC236}">
                    <a16:creationId xmlns:a16="http://schemas.microsoft.com/office/drawing/2014/main" id="{B058696D-B3B3-4F7A-967C-76A9B3133472}"/>
                  </a:ext>
                </a:extLst>
              </p:cNvPr>
              <p:cNvSpPr/>
              <p:nvPr/>
            </p:nvSpPr>
            <p:spPr>
              <a:xfrm>
                <a:off x="2178760" y="1328281"/>
                <a:ext cx="422495" cy="208229"/>
              </a:xfrm>
              <a:custGeom>
                <a:avLst/>
                <a:gdLst>
                  <a:gd name="connsiteX0" fmla="*/ 12072 w 425513"/>
                  <a:gd name="connsiteY0" fmla="*/ 24142 h 208229"/>
                  <a:gd name="connsiteX1" fmla="*/ 0 w 425513"/>
                  <a:gd name="connsiteY1" fmla="*/ 208229 h 208229"/>
                  <a:gd name="connsiteX2" fmla="*/ 347050 w 425513"/>
                  <a:gd name="connsiteY2" fmla="*/ 193140 h 208229"/>
                  <a:gd name="connsiteX3" fmla="*/ 425513 w 425513"/>
                  <a:gd name="connsiteY3" fmla="*/ 120712 h 208229"/>
                  <a:gd name="connsiteX4" fmla="*/ 422495 w 425513"/>
                  <a:gd name="connsiteY4" fmla="*/ 63374 h 208229"/>
                  <a:gd name="connsiteX5" fmla="*/ 413442 w 425513"/>
                  <a:gd name="connsiteY5" fmla="*/ 33196 h 208229"/>
                  <a:gd name="connsiteX6" fmla="*/ 386282 w 425513"/>
                  <a:gd name="connsiteY6" fmla="*/ 15089 h 208229"/>
                  <a:gd name="connsiteX7" fmla="*/ 328943 w 425513"/>
                  <a:gd name="connsiteY7" fmla="*/ 0 h 208229"/>
                  <a:gd name="connsiteX8" fmla="*/ 190123 w 425513"/>
                  <a:gd name="connsiteY8" fmla="*/ 21124 h 208229"/>
                  <a:gd name="connsiteX9" fmla="*/ 144856 w 425513"/>
                  <a:gd name="connsiteY9" fmla="*/ 27160 h 208229"/>
                  <a:gd name="connsiteX10" fmla="*/ 75446 w 425513"/>
                  <a:gd name="connsiteY10" fmla="*/ 33196 h 208229"/>
                  <a:gd name="connsiteX11" fmla="*/ 12072 w 425513"/>
                  <a:gd name="connsiteY11" fmla="*/ 24142 h 208229"/>
                  <a:gd name="connsiteX0" fmla="*/ 12072 w 425513"/>
                  <a:gd name="connsiteY0" fmla="*/ 24142 h 208229"/>
                  <a:gd name="connsiteX1" fmla="*/ 0 w 425513"/>
                  <a:gd name="connsiteY1" fmla="*/ 208229 h 208229"/>
                  <a:gd name="connsiteX2" fmla="*/ 238408 w 425513"/>
                  <a:gd name="connsiteY2" fmla="*/ 205212 h 208229"/>
                  <a:gd name="connsiteX3" fmla="*/ 347050 w 425513"/>
                  <a:gd name="connsiteY3" fmla="*/ 193140 h 208229"/>
                  <a:gd name="connsiteX4" fmla="*/ 425513 w 425513"/>
                  <a:gd name="connsiteY4" fmla="*/ 120712 h 208229"/>
                  <a:gd name="connsiteX5" fmla="*/ 422495 w 425513"/>
                  <a:gd name="connsiteY5" fmla="*/ 63374 h 208229"/>
                  <a:gd name="connsiteX6" fmla="*/ 413442 w 425513"/>
                  <a:gd name="connsiteY6" fmla="*/ 33196 h 208229"/>
                  <a:gd name="connsiteX7" fmla="*/ 386282 w 425513"/>
                  <a:gd name="connsiteY7" fmla="*/ 15089 h 208229"/>
                  <a:gd name="connsiteX8" fmla="*/ 328943 w 425513"/>
                  <a:gd name="connsiteY8" fmla="*/ 0 h 208229"/>
                  <a:gd name="connsiteX9" fmla="*/ 190123 w 425513"/>
                  <a:gd name="connsiteY9" fmla="*/ 21124 h 208229"/>
                  <a:gd name="connsiteX10" fmla="*/ 144856 w 425513"/>
                  <a:gd name="connsiteY10" fmla="*/ 27160 h 208229"/>
                  <a:gd name="connsiteX11" fmla="*/ 75446 w 425513"/>
                  <a:gd name="connsiteY11" fmla="*/ 33196 h 208229"/>
                  <a:gd name="connsiteX12" fmla="*/ 12072 w 425513"/>
                  <a:gd name="connsiteY12" fmla="*/ 24142 h 208229"/>
                  <a:gd name="connsiteX0" fmla="*/ 12072 w 425513"/>
                  <a:gd name="connsiteY0" fmla="*/ 24142 h 208229"/>
                  <a:gd name="connsiteX1" fmla="*/ 0 w 425513"/>
                  <a:gd name="connsiteY1" fmla="*/ 208229 h 208229"/>
                  <a:gd name="connsiteX2" fmla="*/ 238408 w 425513"/>
                  <a:gd name="connsiteY2" fmla="*/ 205212 h 208229"/>
                  <a:gd name="connsiteX3" fmla="*/ 359121 w 425513"/>
                  <a:gd name="connsiteY3" fmla="*/ 193140 h 208229"/>
                  <a:gd name="connsiteX4" fmla="*/ 425513 w 425513"/>
                  <a:gd name="connsiteY4" fmla="*/ 120712 h 208229"/>
                  <a:gd name="connsiteX5" fmla="*/ 422495 w 425513"/>
                  <a:gd name="connsiteY5" fmla="*/ 63374 h 208229"/>
                  <a:gd name="connsiteX6" fmla="*/ 413442 w 425513"/>
                  <a:gd name="connsiteY6" fmla="*/ 33196 h 208229"/>
                  <a:gd name="connsiteX7" fmla="*/ 386282 w 425513"/>
                  <a:gd name="connsiteY7" fmla="*/ 15089 h 208229"/>
                  <a:gd name="connsiteX8" fmla="*/ 328943 w 425513"/>
                  <a:gd name="connsiteY8" fmla="*/ 0 h 208229"/>
                  <a:gd name="connsiteX9" fmla="*/ 190123 w 425513"/>
                  <a:gd name="connsiteY9" fmla="*/ 21124 h 208229"/>
                  <a:gd name="connsiteX10" fmla="*/ 144856 w 425513"/>
                  <a:gd name="connsiteY10" fmla="*/ 27160 h 208229"/>
                  <a:gd name="connsiteX11" fmla="*/ 75446 w 425513"/>
                  <a:gd name="connsiteY11" fmla="*/ 33196 h 208229"/>
                  <a:gd name="connsiteX12" fmla="*/ 12072 w 425513"/>
                  <a:gd name="connsiteY12" fmla="*/ 24142 h 208229"/>
                  <a:gd name="connsiteX0" fmla="*/ 12072 w 422495"/>
                  <a:gd name="connsiteY0" fmla="*/ 24142 h 208229"/>
                  <a:gd name="connsiteX1" fmla="*/ 0 w 422495"/>
                  <a:gd name="connsiteY1" fmla="*/ 208229 h 208229"/>
                  <a:gd name="connsiteX2" fmla="*/ 238408 w 422495"/>
                  <a:gd name="connsiteY2" fmla="*/ 205212 h 208229"/>
                  <a:gd name="connsiteX3" fmla="*/ 359121 w 422495"/>
                  <a:gd name="connsiteY3" fmla="*/ 193140 h 208229"/>
                  <a:gd name="connsiteX4" fmla="*/ 413442 w 422495"/>
                  <a:gd name="connsiteY4" fmla="*/ 141837 h 208229"/>
                  <a:gd name="connsiteX5" fmla="*/ 422495 w 422495"/>
                  <a:gd name="connsiteY5" fmla="*/ 63374 h 208229"/>
                  <a:gd name="connsiteX6" fmla="*/ 413442 w 422495"/>
                  <a:gd name="connsiteY6" fmla="*/ 33196 h 208229"/>
                  <a:gd name="connsiteX7" fmla="*/ 386282 w 422495"/>
                  <a:gd name="connsiteY7" fmla="*/ 15089 h 208229"/>
                  <a:gd name="connsiteX8" fmla="*/ 328943 w 422495"/>
                  <a:gd name="connsiteY8" fmla="*/ 0 h 208229"/>
                  <a:gd name="connsiteX9" fmla="*/ 190123 w 422495"/>
                  <a:gd name="connsiteY9" fmla="*/ 21124 h 208229"/>
                  <a:gd name="connsiteX10" fmla="*/ 144856 w 422495"/>
                  <a:gd name="connsiteY10" fmla="*/ 27160 h 208229"/>
                  <a:gd name="connsiteX11" fmla="*/ 75446 w 422495"/>
                  <a:gd name="connsiteY11" fmla="*/ 33196 h 208229"/>
                  <a:gd name="connsiteX12" fmla="*/ 12072 w 422495"/>
                  <a:gd name="connsiteY12" fmla="*/ 24142 h 2082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422495" h="208229">
                    <a:moveTo>
                      <a:pt x="12072" y="24142"/>
                    </a:moveTo>
                    <a:lnTo>
                      <a:pt x="0" y="208229"/>
                    </a:lnTo>
                    <a:cubicBezTo>
                      <a:pt x="85505" y="205211"/>
                      <a:pt x="152903" y="208230"/>
                      <a:pt x="238408" y="205212"/>
                    </a:cubicBezTo>
                    <a:lnTo>
                      <a:pt x="359121" y="193140"/>
                    </a:lnTo>
                    <a:lnTo>
                      <a:pt x="413442" y="141837"/>
                    </a:lnTo>
                    <a:lnTo>
                      <a:pt x="422495" y="63374"/>
                    </a:lnTo>
                    <a:lnTo>
                      <a:pt x="413442" y="33196"/>
                    </a:lnTo>
                    <a:lnTo>
                      <a:pt x="386282" y="15089"/>
                    </a:lnTo>
                    <a:lnTo>
                      <a:pt x="328943" y="0"/>
                    </a:lnTo>
                    <a:lnTo>
                      <a:pt x="190123" y="21124"/>
                    </a:lnTo>
                    <a:lnTo>
                      <a:pt x="144856" y="27160"/>
                    </a:lnTo>
                    <a:lnTo>
                      <a:pt x="75446" y="33196"/>
                    </a:lnTo>
                    <a:lnTo>
                      <a:pt x="12072" y="24142"/>
                    </a:lnTo>
                    <a:close/>
                  </a:path>
                </a:pathLst>
              </a:custGeom>
              <a:noFill/>
              <a:ln>
                <a:solidFill>
                  <a:srgbClr val="90E9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dirty="0"/>
              </a:p>
            </p:txBody>
          </p:sp>
          <p:sp>
            <p:nvSpPr>
              <p:cNvPr id="30" name="Freeform: Shape 29">
                <a:extLst>
                  <a:ext uri="{FF2B5EF4-FFF2-40B4-BE49-F238E27FC236}">
                    <a16:creationId xmlns:a16="http://schemas.microsoft.com/office/drawing/2014/main" id="{3FD0D364-F7AF-491A-A2C6-F1E2FA21333A}"/>
                  </a:ext>
                </a:extLst>
              </p:cNvPr>
              <p:cNvSpPr/>
              <p:nvPr/>
            </p:nvSpPr>
            <p:spPr>
              <a:xfrm>
                <a:off x="2218200" y="2104336"/>
                <a:ext cx="398248" cy="251526"/>
              </a:xfrm>
              <a:custGeom>
                <a:avLst/>
                <a:gdLst>
                  <a:gd name="connsiteX0" fmla="*/ 0 w 398248"/>
                  <a:gd name="connsiteY0" fmla="*/ 36681 h 251526"/>
                  <a:gd name="connsiteX1" fmla="*/ 15720 w 398248"/>
                  <a:gd name="connsiteY1" fmla="*/ 248906 h 251526"/>
                  <a:gd name="connsiteX2" fmla="*/ 117902 w 398248"/>
                  <a:gd name="connsiteY2" fmla="*/ 251526 h 251526"/>
                  <a:gd name="connsiteX3" fmla="*/ 201744 w 398248"/>
                  <a:gd name="connsiteY3" fmla="*/ 230565 h 251526"/>
                  <a:gd name="connsiteX4" fmla="*/ 241045 w 398248"/>
                  <a:gd name="connsiteY4" fmla="*/ 238426 h 251526"/>
                  <a:gd name="connsiteX5" fmla="*/ 280346 w 398248"/>
                  <a:gd name="connsiteY5" fmla="*/ 230565 h 251526"/>
                  <a:gd name="connsiteX6" fmla="*/ 311786 w 398248"/>
                  <a:gd name="connsiteY6" fmla="*/ 225325 h 251526"/>
                  <a:gd name="connsiteX7" fmla="*/ 395628 w 398248"/>
                  <a:gd name="connsiteY7" fmla="*/ 230565 h 251526"/>
                  <a:gd name="connsiteX8" fmla="*/ 398248 w 398248"/>
                  <a:gd name="connsiteY8" fmla="*/ 136243 h 251526"/>
                  <a:gd name="connsiteX9" fmla="*/ 385148 w 398248"/>
                  <a:gd name="connsiteY9" fmla="*/ 96943 h 251526"/>
                  <a:gd name="connsiteX10" fmla="*/ 366808 w 398248"/>
                  <a:gd name="connsiteY10" fmla="*/ 15721 h 251526"/>
                  <a:gd name="connsiteX11" fmla="*/ 358947 w 398248"/>
                  <a:gd name="connsiteY11" fmla="*/ 7861 h 251526"/>
                  <a:gd name="connsiteX12" fmla="*/ 340607 w 398248"/>
                  <a:gd name="connsiteY12" fmla="*/ 2620 h 251526"/>
                  <a:gd name="connsiteX13" fmla="*/ 309166 w 398248"/>
                  <a:gd name="connsiteY13" fmla="*/ 0 h 251526"/>
                  <a:gd name="connsiteX14" fmla="*/ 269865 w 398248"/>
                  <a:gd name="connsiteY14" fmla="*/ 2620 h 251526"/>
                  <a:gd name="connsiteX15" fmla="*/ 230565 w 398248"/>
                  <a:gd name="connsiteY15" fmla="*/ 7861 h 251526"/>
                  <a:gd name="connsiteX16" fmla="*/ 191264 w 398248"/>
                  <a:gd name="connsiteY16" fmla="*/ 15721 h 251526"/>
                  <a:gd name="connsiteX17" fmla="*/ 178163 w 398248"/>
                  <a:gd name="connsiteY17" fmla="*/ 18341 h 251526"/>
                  <a:gd name="connsiteX18" fmla="*/ 102182 w 398248"/>
                  <a:gd name="connsiteY18" fmla="*/ 15721 h 251526"/>
                  <a:gd name="connsiteX19" fmla="*/ 102182 w 398248"/>
                  <a:gd name="connsiteY19" fmla="*/ 15721 h 251526"/>
                  <a:gd name="connsiteX20" fmla="*/ 60261 w 398248"/>
                  <a:gd name="connsiteY20" fmla="*/ 31441 h 251526"/>
                  <a:gd name="connsiteX21" fmla="*/ 0 w 398248"/>
                  <a:gd name="connsiteY21" fmla="*/ 36681 h 25152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398248" h="251526">
                    <a:moveTo>
                      <a:pt x="0" y="36681"/>
                    </a:moveTo>
                    <a:lnTo>
                      <a:pt x="15720" y="248906"/>
                    </a:lnTo>
                    <a:lnTo>
                      <a:pt x="117902" y="251526"/>
                    </a:lnTo>
                    <a:lnTo>
                      <a:pt x="201744" y="230565"/>
                    </a:lnTo>
                    <a:lnTo>
                      <a:pt x="241045" y="238426"/>
                    </a:lnTo>
                    <a:lnTo>
                      <a:pt x="280346" y="230565"/>
                    </a:lnTo>
                    <a:lnTo>
                      <a:pt x="311786" y="225325"/>
                    </a:lnTo>
                    <a:lnTo>
                      <a:pt x="395628" y="230565"/>
                    </a:lnTo>
                    <a:cubicBezTo>
                      <a:pt x="396501" y="199124"/>
                      <a:pt x="397375" y="167684"/>
                      <a:pt x="398248" y="136243"/>
                    </a:cubicBezTo>
                    <a:lnTo>
                      <a:pt x="385148" y="96943"/>
                    </a:lnTo>
                    <a:lnTo>
                      <a:pt x="366808" y="15721"/>
                    </a:lnTo>
                    <a:lnTo>
                      <a:pt x="358947" y="7861"/>
                    </a:lnTo>
                    <a:lnTo>
                      <a:pt x="340607" y="2620"/>
                    </a:lnTo>
                    <a:lnTo>
                      <a:pt x="309166" y="0"/>
                    </a:lnTo>
                    <a:lnTo>
                      <a:pt x="269865" y="2620"/>
                    </a:lnTo>
                    <a:lnTo>
                      <a:pt x="230565" y="7861"/>
                    </a:lnTo>
                    <a:lnTo>
                      <a:pt x="191264" y="15721"/>
                    </a:lnTo>
                    <a:lnTo>
                      <a:pt x="178163" y="18341"/>
                    </a:lnTo>
                    <a:lnTo>
                      <a:pt x="102182" y="15721"/>
                    </a:lnTo>
                    <a:lnTo>
                      <a:pt x="102182" y="15721"/>
                    </a:lnTo>
                    <a:lnTo>
                      <a:pt x="60261" y="31441"/>
                    </a:lnTo>
                    <a:lnTo>
                      <a:pt x="0" y="36681"/>
                    </a:lnTo>
                    <a:close/>
                  </a:path>
                </a:pathLst>
              </a:custGeom>
              <a:noFill/>
              <a:ln>
                <a:solidFill>
                  <a:srgbClr val="90E9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dirty="0"/>
              </a:p>
            </p:txBody>
          </p:sp>
          <p:sp>
            <p:nvSpPr>
              <p:cNvPr id="71" name="Freeform: Shape 70">
                <a:extLst>
                  <a:ext uri="{FF2B5EF4-FFF2-40B4-BE49-F238E27FC236}">
                    <a16:creationId xmlns:a16="http://schemas.microsoft.com/office/drawing/2014/main" id="{2C3BB413-16B0-4D78-8AB8-D96F1E48BBDB}"/>
                  </a:ext>
                </a:extLst>
              </p:cNvPr>
              <p:cNvSpPr/>
              <p:nvPr/>
            </p:nvSpPr>
            <p:spPr>
              <a:xfrm>
                <a:off x="2212959" y="2696469"/>
                <a:ext cx="495191" cy="199125"/>
              </a:xfrm>
              <a:custGeom>
                <a:avLst/>
                <a:gdLst>
                  <a:gd name="connsiteX0" fmla="*/ 36681 w 495191"/>
                  <a:gd name="connsiteY0" fmla="*/ 0 h 199125"/>
                  <a:gd name="connsiteX1" fmla="*/ 0 w 495191"/>
                  <a:gd name="connsiteY1" fmla="*/ 199125 h 199125"/>
                  <a:gd name="connsiteX2" fmla="*/ 60262 w 495191"/>
                  <a:gd name="connsiteY2" fmla="*/ 193885 h 199125"/>
                  <a:gd name="connsiteX3" fmla="*/ 86462 w 495191"/>
                  <a:gd name="connsiteY3" fmla="*/ 193885 h 199125"/>
                  <a:gd name="connsiteX4" fmla="*/ 188645 w 495191"/>
                  <a:gd name="connsiteY4" fmla="*/ 162444 h 199125"/>
                  <a:gd name="connsiteX5" fmla="*/ 314407 w 495191"/>
                  <a:gd name="connsiteY5" fmla="*/ 128383 h 199125"/>
                  <a:gd name="connsiteX6" fmla="*/ 495191 w 495191"/>
                  <a:gd name="connsiteY6" fmla="*/ 68122 h 199125"/>
                  <a:gd name="connsiteX7" fmla="*/ 474231 w 495191"/>
                  <a:gd name="connsiteY7" fmla="*/ 44541 h 199125"/>
                  <a:gd name="connsiteX8" fmla="*/ 445410 w 495191"/>
                  <a:gd name="connsiteY8" fmla="*/ 52402 h 199125"/>
                  <a:gd name="connsiteX9" fmla="*/ 366808 w 495191"/>
                  <a:gd name="connsiteY9" fmla="*/ 49781 h 199125"/>
                  <a:gd name="connsiteX10" fmla="*/ 319647 w 495191"/>
                  <a:gd name="connsiteY10" fmla="*/ 55022 h 199125"/>
                  <a:gd name="connsiteX11" fmla="*/ 246286 w 495191"/>
                  <a:gd name="connsiteY11" fmla="*/ 47161 h 199125"/>
                  <a:gd name="connsiteX12" fmla="*/ 201745 w 495191"/>
                  <a:gd name="connsiteY12" fmla="*/ 44541 h 199125"/>
                  <a:gd name="connsiteX13" fmla="*/ 123143 w 495191"/>
                  <a:gd name="connsiteY13" fmla="*/ 23581 h 199125"/>
                  <a:gd name="connsiteX14" fmla="*/ 36681 w 495191"/>
                  <a:gd name="connsiteY14" fmla="*/ 0 h 1991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Lst>
                <a:rect l="l" t="t" r="r" b="b"/>
                <a:pathLst>
                  <a:path w="495191" h="199125">
                    <a:moveTo>
                      <a:pt x="36681" y="0"/>
                    </a:moveTo>
                    <a:lnTo>
                      <a:pt x="0" y="199125"/>
                    </a:lnTo>
                    <a:lnTo>
                      <a:pt x="60262" y="193885"/>
                    </a:lnTo>
                    <a:lnTo>
                      <a:pt x="86462" y="193885"/>
                    </a:lnTo>
                    <a:lnTo>
                      <a:pt x="188645" y="162444"/>
                    </a:lnTo>
                    <a:lnTo>
                      <a:pt x="314407" y="128383"/>
                    </a:lnTo>
                    <a:lnTo>
                      <a:pt x="495191" y="68122"/>
                    </a:lnTo>
                    <a:lnTo>
                      <a:pt x="474231" y="44541"/>
                    </a:lnTo>
                    <a:lnTo>
                      <a:pt x="445410" y="52402"/>
                    </a:lnTo>
                    <a:lnTo>
                      <a:pt x="366808" y="49781"/>
                    </a:lnTo>
                    <a:lnTo>
                      <a:pt x="319647" y="55022"/>
                    </a:lnTo>
                    <a:lnTo>
                      <a:pt x="246286" y="47161"/>
                    </a:lnTo>
                    <a:lnTo>
                      <a:pt x="201745" y="44541"/>
                    </a:lnTo>
                    <a:lnTo>
                      <a:pt x="123143" y="23581"/>
                    </a:lnTo>
                    <a:lnTo>
                      <a:pt x="36681" y="0"/>
                    </a:lnTo>
                    <a:close/>
                  </a:path>
                </a:pathLst>
              </a:custGeom>
              <a:noFill/>
              <a:ln>
                <a:solidFill>
                  <a:srgbClr val="90E9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dirty="0"/>
              </a:p>
            </p:txBody>
          </p:sp>
          <p:sp>
            <p:nvSpPr>
              <p:cNvPr id="102" name="TextBox 101">
                <a:extLst>
                  <a:ext uri="{FF2B5EF4-FFF2-40B4-BE49-F238E27FC236}">
                    <a16:creationId xmlns:a16="http://schemas.microsoft.com/office/drawing/2014/main" id="{FE9ED91A-252F-44AE-82AF-0F63133FA9A0}"/>
                  </a:ext>
                </a:extLst>
              </p:cNvPr>
              <p:cNvSpPr txBox="1"/>
              <p:nvPr/>
            </p:nvSpPr>
            <p:spPr>
              <a:xfrm>
                <a:off x="1413182" y="1148947"/>
                <a:ext cx="331232" cy="243567"/>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C1</a:t>
                </a:r>
              </a:p>
            </p:txBody>
          </p:sp>
          <p:sp>
            <p:nvSpPr>
              <p:cNvPr id="103" name="TextBox 102">
                <a:extLst>
                  <a:ext uri="{FF2B5EF4-FFF2-40B4-BE49-F238E27FC236}">
                    <a16:creationId xmlns:a16="http://schemas.microsoft.com/office/drawing/2014/main" id="{FDEABC32-CF56-49CA-90E8-E84D93D608F2}"/>
                  </a:ext>
                </a:extLst>
              </p:cNvPr>
              <p:cNvSpPr txBox="1"/>
              <p:nvPr/>
            </p:nvSpPr>
            <p:spPr>
              <a:xfrm>
                <a:off x="1413182" y="1633843"/>
                <a:ext cx="331232" cy="243567"/>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C2</a:t>
                </a:r>
              </a:p>
            </p:txBody>
          </p:sp>
          <p:sp>
            <p:nvSpPr>
              <p:cNvPr id="104" name="TextBox 103">
                <a:extLst>
                  <a:ext uri="{FF2B5EF4-FFF2-40B4-BE49-F238E27FC236}">
                    <a16:creationId xmlns:a16="http://schemas.microsoft.com/office/drawing/2014/main" id="{DC789F15-368C-467D-A372-2CA932EAA0B3}"/>
                  </a:ext>
                </a:extLst>
              </p:cNvPr>
              <p:cNvSpPr txBox="1"/>
              <p:nvPr/>
            </p:nvSpPr>
            <p:spPr>
              <a:xfrm>
                <a:off x="1413182" y="2118739"/>
                <a:ext cx="331232" cy="243567"/>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C3</a:t>
                </a:r>
              </a:p>
            </p:txBody>
          </p:sp>
          <p:sp>
            <p:nvSpPr>
              <p:cNvPr id="105" name="TextBox 104">
                <a:extLst>
                  <a:ext uri="{FF2B5EF4-FFF2-40B4-BE49-F238E27FC236}">
                    <a16:creationId xmlns:a16="http://schemas.microsoft.com/office/drawing/2014/main" id="{CFE5DBB7-E9F9-4636-83D6-5AA979F1950C}"/>
                  </a:ext>
                </a:extLst>
              </p:cNvPr>
              <p:cNvSpPr txBox="1"/>
              <p:nvPr/>
            </p:nvSpPr>
            <p:spPr>
              <a:xfrm>
                <a:off x="1413182" y="2603634"/>
                <a:ext cx="331232" cy="243567"/>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C4</a:t>
                </a:r>
              </a:p>
            </p:txBody>
          </p:sp>
          <p:pic>
            <p:nvPicPr>
              <p:cNvPr id="37" name="Picture 36">
                <a:extLst>
                  <a:ext uri="{FF2B5EF4-FFF2-40B4-BE49-F238E27FC236}">
                    <a16:creationId xmlns:a16="http://schemas.microsoft.com/office/drawing/2014/main" id="{09967A27-CA95-3D5F-43B2-15DB01304FBC}"/>
                  </a:ext>
                </a:extLst>
              </p:cNvPr>
              <p:cNvPicPr>
                <a:picLocks noChangeAspect="1"/>
              </p:cNvPicPr>
              <p:nvPr/>
            </p:nvPicPr>
            <p:blipFill rotWithShape="1">
              <a:blip r:embed="rId18">
                <a:extLst>
                  <a:ext uri="{BEBA8EAE-BF5A-486C-A8C5-ECC9F3942E4B}">
                    <a14:imgProps xmlns:a14="http://schemas.microsoft.com/office/drawing/2010/main">
                      <a14:imgLayer r:embed="rId19">
                        <a14:imgEffect>
                          <a14:backgroundRemoval t="5814" b="67636" l="3217" r="58348">
                            <a14:foregroundMark x1="6696" y1="42636" x2="6522" y2="56783"/>
                            <a14:foregroundMark x1="3739" y1="61047" x2="3478" y2="46318"/>
                            <a14:foregroundMark x1="28696" y1="56395" x2="35913" y2="65698"/>
                            <a14:foregroundMark x1="35913" y1="65698" x2="46696" y2="67636"/>
                            <a14:foregroundMark x1="58174" y1="61822" x2="58348" y2="53488"/>
                            <a14:foregroundMark x1="56696" y1="7946" x2="56696" y2="5814"/>
                          </a14:backgroundRemoval>
                        </a14:imgEffect>
                      </a14:imgLayer>
                    </a14:imgProps>
                  </a:ext>
                </a:extLst>
              </a:blip>
              <a:srcRect t="809" r="37634" b="28041"/>
              <a:stretch/>
            </p:blipFill>
            <p:spPr>
              <a:xfrm flipH="1">
                <a:off x="1665110" y="1525532"/>
                <a:ext cx="929506" cy="475813"/>
              </a:xfrm>
              <a:prstGeom prst="rect">
                <a:avLst/>
              </a:prstGeom>
            </p:spPr>
          </p:pic>
          <p:sp>
            <p:nvSpPr>
              <p:cNvPr id="42" name="Freeform 41">
                <a:extLst>
                  <a:ext uri="{FF2B5EF4-FFF2-40B4-BE49-F238E27FC236}">
                    <a16:creationId xmlns:a16="http://schemas.microsoft.com/office/drawing/2014/main" id="{14A2DEE0-CB3B-D2F5-C73E-891084E3B1C9}"/>
                  </a:ext>
                </a:extLst>
              </p:cNvPr>
              <p:cNvSpPr/>
              <p:nvPr/>
            </p:nvSpPr>
            <p:spPr>
              <a:xfrm>
                <a:off x="2168525" y="1765300"/>
                <a:ext cx="377825" cy="184150"/>
              </a:xfrm>
              <a:custGeom>
                <a:avLst/>
                <a:gdLst>
                  <a:gd name="connsiteX0" fmla="*/ 0 w 377825"/>
                  <a:gd name="connsiteY0" fmla="*/ 19050 h 184150"/>
                  <a:gd name="connsiteX1" fmla="*/ 15875 w 377825"/>
                  <a:gd name="connsiteY1" fmla="*/ 184150 h 184150"/>
                  <a:gd name="connsiteX2" fmla="*/ 228600 w 377825"/>
                  <a:gd name="connsiteY2" fmla="*/ 130175 h 184150"/>
                  <a:gd name="connsiteX3" fmla="*/ 234950 w 377825"/>
                  <a:gd name="connsiteY3" fmla="*/ 149225 h 184150"/>
                  <a:gd name="connsiteX4" fmla="*/ 247650 w 377825"/>
                  <a:gd name="connsiteY4" fmla="*/ 165100 h 184150"/>
                  <a:gd name="connsiteX5" fmla="*/ 327025 w 377825"/>
                  <a:gd name="connsiteY5" fmla="*/ 168275 h 184150"/>
                  <a:gd name="connsiteX6" fmla="*/ 365125 w 377825"/>
                  <a:gd name="connsiteY6" fmla="*/ 149225 h 184150"/>
                  <a:gd name="connsiteX7" fmla="*/ 377825 w 377825"/>
                  <a:gd name="connsiteY7" fmla="*/ 117475 h 184150"/>
                  <a:gd name="connsiteX8" fmla="*/ 377825 w 377825"/>
                  <a:gd name="connsiteY8" fmla="*/ 63500 h 184150"/>
                  <a:gd name="connsiteX9" fmla="*/ 336550 w 377825"/>
                  <a:gd name="connsiteY9" fmla="*/ 73025 h 184150"/>
                  <a:gd name="connsiteX10" fmla="*/ 304800 w 377825"/>
                  <a:gd name="connsiteY10" fmla="*/ 57150 h 184150"/>
                  <a:gd name="connsiteX11" fmla="*/ 231775 w 377825"/>
                  <a:gd name="connsiteY11" fmla="*/ 53975 h 184150"/>
                  <a:gd name="connsiteX12" fmla="*/ 219075 w 377825"/>
                  <a:gd name="connsiteY12" fmla="*/ 38100 h 184150"/>
                  <a:gd name="connsiteX13" fmla="*/ 184150 w 377825"/>
                  <a:gd name="connsiteY13" fmla="*/ 19050 h 184150"/>
                  <a:gd name="connsiteX14" fmla="*/ 152400 w 377825"/>
                  <a:gd name="connsiteY14" fmla="*/ 3175 h 184150"/>
                  <a:gd name="connsiteX15" fmla="*/ 136525 w 377825"/>
                  <a:gd name="connsiteY15" fmla="*/ 0 h 184150"/>
                  <a:gd name="connsiteX16" fmla="*/ 107950 w 377825"/>
                  <a:gd name="connsiteY16" fmla="*/ 3175 h 184150"/>
                  <a:gd name="connsiteX17" fmla="*/ 76200 w 377825"/>
                  <a:gd name="connsiteY17" fmla="*/ 19050 h 184150"/>
                  <a:gd name="connsiteX18" fmla="*/ 0 w 377825"/>
                  <a:gd name="connsiteY18" fmla="*/ 19050 h 1841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377825" h="184150">
                    <a:moveTo>
                      <a:pt x="0" y="19050"/>
                    </a:moveTo>
                    <a:lnTo>
                      <a:pt x="15875" y="184150"/>
                    </a:lnTo>
                    <a:lnTo>
                      <a:pt x="228600" y="130175"/>
                    </a:lnTo>
                    <a:lnTo>
                      <a:pt x="234950" y="149225"/>
                    </a:lnTo>
                    <a:lnTo>
                      <a:pt x="247650" y="165100"/>
                    </a:lnTo>
                    <a:lnTo>
                      <a:pt x="327025" y="168275"/>
                    </a:lnTo>
                    <a:lnTo>
                      <a:pt x="365125" y="149225"/>
                    </a:lnTo>
                    <a:lnTo>
                      <a:pt x="377825" y="117475"/>
                    </a:lnTo>
                    <a:lnTo>
                      <a:pt x="377825" y="63500"/>
                    </a:lnTo>
                    <a:lnTo>
                      <a:pt x="336550" y="73025"/>
                    </a:lnTo>
                    <a:lnTo>
                      <a:pt x="304800" y="57150"/>
                    </a:lnTo>
                    <a:lnTo>
                      <a:pt x="231775" y="53975"/>
                    </a:lnTo>
                    <a:lnTo>
                      <a:pt x="219075" y="38100"/>
                    </a:lnTo>
                    <a:lnTo>
                      <a:pt x="184150" y="19050"/>
                    </a:lnTo>
                    <a:lnTo>
                      <a:pt x="152400" y="3175"/>
                    </a:lnTo>
                    <a:lnTo>
                      <a:pt x="136525" y="0"/>
                    </a:lnTo>
                    <a:lnTo>
                      <a:pt x="107950" y="3175"/>
                    </a:lnTo>
                    <a:lnTo>
                      <a:pt x="76200" y="19050"/>
                    </a:lnTo>
                    <a:lnTo>
                      <a:pt x="0" y="19050"/>
                    </a:lnTo>
                    <a:close/>
                  </a:path>
                </a:pathLst>
              </a:custGeom>
              <a:noFill/>
              <a:ln>
                <a:solidFill>
                  <a:srgbClr val="90E90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929"/>
              </a:p>
            </p:txBody>
          </p:sp>
        </p:grpSp>
      </p:grpSp>
      <p:grpSp>
        <p:nvGrpSpPr>
          <p:cNvPr id="17" name="Group 16">
            <a:extLst>
              <a:ext uri="{FF2B5EF4-FFF2-40B4-BE49-F238E27FC236}">
                <a16:creationId xmlns:a16="http://schemas.microsoft.com/office/drawing/2014/main" id="{A4DA7CB2-3417-5D13-8CF8-43AB0673AC81}"/>
              </a:ext>
            </a:extLst>
          </p:cNvPr>
          <p:cNvGrpSpPr/>
          <p:nvPr/>
        </p:nvGrpSpPr>
        <p:grpSpPr>
          <a:xfrm>
            <a:off x="3374357" y="871863"/>
            <a:ext cx="3217167" cy="2927610"/>
            <a:chOff x="361660" y="4336613"/>
            <a:chExt cx="3433727" cy="3124680"/>
          </a:xfrm>
        </p:grpSpPr>
        <p:grpSp>
          <p:nvGrpSpPr>
            <p:cNvPr id="16" name="Group 15">
              <a:extLst>
                <a:ext uri="{FF2B5EF4-FFF2-40B4-BE49-F238E27FC236}">
                  <a16:creationId xmlns:a16="http://schemas.microsoft.com/office/drawing/2014/main" id="{019BF19E-AEBF-03E3-AE80-669E67823055}"/>
                </a:ext>
              </a:extLst>
            </p:cNvPr>
            <p:cNvGrpSpPr/>
            <p:nvPr/>
          </p:nvGrpSpPr>
          <p:grpSpPr>
            <a:xfrm>
              <a:off x="361660" y="4336613"/>
              <a:ext cx="3433727" cy="3124680"/>
              <a:chOff x="361660" y="4336613"/>
              <a:chExt cx="3433727" cy="3124680"/>
            </a:xfrm>
          </p:grpSpPr>
          <p:pic>
            <p:nvPicPr>
              <p:cNvPr id="7" name="Picture 6" descr="A graph with red and blue circles&#10;&#10;Description automatically generated">
                <a:extLst>
                  <a:ext uri="{FF2B5EF4-FFF2-40B4-BE49-F238E27FC236}">
                    <a16:creationId xmlns:a16="http://schemas.microsoft.com/office/drawing/2014/main" id="{2D0FB17B-E9DF-255B-D5A4-24945B2F2891}"/>
                  </a:ext>
                </a:extLst>
              </p:cNvPr>
              <p:cNvPicPr>
                <a:picLocks noChangeAspect="1"/>
              </p:cNvPicPr>
              <p:nvPr/>
            </p:nvPicPr>
            <p:blipFill rotWithShape="1">
              <a:blip r:embed="rId20">
                <a:extLst>
                  <a:ext uri="{BEBA8EAE-BF5A-486C-A8C5-ECC9F3942E4B}">
                    <a14:imgProps xmlns:a14="http://schemas.microsoft.com/office/drawing/2010/main">
                      <a14:imgLayer r:embed="rId21">
                        <a14:imgEffect>
                          <a14:sharpenSoften amount="50000"/>
                        </a14:imgEffect>
                      </a14:imgLayer>
                    </a14:imgProps>
                  </a:ext>
                </a:extLst>
              </a:blip>
              <a:srcRect l="24356" t="24604" r="31858" b="24893"/>
              <a:stretch/>
            </p:blipFill>
            <p:spPr>
              <a:xfrm>
                <a:off x="361660" y="4336613"/>
                <a:ext cx="3378307" cy="2975595"/>
              </a:xfrm>
              <a:prstGeom prst="rect">
                <a:avLst/>
              </a:prstGeom>
            </p:spPr>
          </p:pic>
          <p:sp>
            <p:nvSpPr>
              <p:cNvPr id="10" name="Oval 9">
                <a:extLst>
                  <a:ext uri="{FF2B5EF4-FFF2-40B4-BE49-F238E27FC236}">
                    <a16:creationId xmlns:a16="http://schemas.microsoft.com/office/drawing/2014/main" id="{834EDE74-ABF0-53E8-A4EF-64E1E9ACC206}"/>
                  </a:ext>
                </a:extLst>
              </p:cNvPr>
              <p:cNvSpPr/>
              <p:nvPr/>
            </p:nvSpPr>
            <p:spPr>
              <a:xfrm>
                <a:off x="3511463" y="6801634"/>
                <a:ext cx="283924" cy="137786"/>
              </a:xfrm>
              <a:prstGeom prst="ellipse">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500"/>
              </a:p>
            </p:txBody>
          </p:sp>
          <p:pic>
            <p:nvPicPr>
              <p:cNvPr id="12" name="Picture 11" descr="A graph with red and blue circles&#10;&#10;Description automatically generated">
                <a:extLst>
                  <a:ext uri="{FF2B5EF4-FFF2-40B4-BE49-F238E27FC236}">
                    <a16:creationId xmlns:a16="http://schemas.microsoft.com/office/drawing/2014/main" id="{F772D3E1-C7ED-9102-2D58-816CCDC758B9}"/>
                  </a:ext>
                </a:extLst>
              </p:cNvPr>
              <p:cNvPicPr>
                <a:picLocks noChangeAspect="1"/>
              </p:cNvPicPr>
              <p:nvPr/>
            </p:nvPicPr>
            <p:blipFill rotWithShape="1">
              <a:blip r:embed="rId22"/>
              <a:srcRect l="35476" t="75564" r="46904" b="20225"/>
              <a:stretch/>
            </p:blipFill>
            <p:spPr>
              <a:xfrm rot="198919">
                <a:off x="1224689" y="7158554"/>
                <a:ext cx="1302441" cy="237716"/>
              </a:xfrm>
              <a:prstGeom prst="rect">
                <a:avLst/>
              </a:prstGeom>
            </p:spPr>
          </p:pic>
          <p:pic>
            <p:nvPicPr>
              <p:cNvPr id="13" name="Picture 12" descr="A graph with red and blue circles&#10;&#10;Description automatically generated">
                <a:extLst>
                  <a:ext uri="{FF2B5EF4-FFF2-40B4-BE49-F238E27FC236}">
                    <a16:creationId xmlns:a16="http://schemas.microsoft.com/office/drawing/2014/main" id="{D8E0B371-083F-A63C-9569-8FBA9BB8D91F}"/>
                  </a:ext>
                </a:extLst>
              </p:cNvPr>
              <p:cNvPicPr>
                <a:picLocks noChangeAspect="1"/>
              </p:cNvPicPr>
              <p:nvPr/>
            </p:nvPicPr>
            <p:blipFill rotWithShape="1">
              <a:blip r:embed="rId22"/>
              <a:srcRect l="64453" t="66209" r="19524" b="30236"/>
              <a:stretch/>
            </p:blipFill>
            <p:spPr>
              <a:xfrm rot="16667566">
                <a:off x="3105325" y="6703190"/>
                <a:ext cx="1161995" cy="196890"/>
              </a:xfrm>
              <a:prstGeom prst="rect">
                <a:avLst/>
              </a:prstGeom>
            </p:spPr>
          </p:pic>
          <p:sp>
            <p:nvSpPr>
              <p:cNvPr id="14" name="Oval 13">
                <a:extLst>
                  <a:ext uri="{FF2B5EF4-FFF2-40B4-BE49-F238E27FC236}">
                    <a16:creationId xmlns:a16="http://schemas.microsoft.com/office/drawing/2014/main" id="{E26E02DA-6954-6609-C387-37B0B1087825}"/>
                  </a:ext>
                </a:extLst>
              </p:cNvPr>
              <p:cNvSpPr/>
              <p:nvPr/>
            </p:nvSpPr>
            <p:spPr>
              <a:xfrm>
                <a:off x="3406661" y="7323507"/>
                <a:ext cx="283924" cy="137786"/>
              </a:xfrm>
              <a:prstGeom prst="ellipse">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500"/>
              </a:p>
            </p:txBody>
          </p:sp>
        </p:grpSp>
        <p:grpSp>
          <p:nvGrpSpPr>
            <p:cNvPr id="34" name="Group 33">
              <a:extLst>
                <a:ext uri="{FF2B5EF4-FFF2-40B4-BE49-F238E27FC236}">
                  <a16:creationId xmlns:a16="http://schemas.microsoft.com/office/drawing/2014/main" id="{D4ACCBB8-E2B9-6AB2-73BD-7B758DEC6AAA}"/>
                </a:ext>
              </a:extLst>
            </p:cNvPr>
            <p:cNvGrpSpPr/>
            <p:nvPr/>
          </p:nvGrpSpPr>
          <p:grpSpPr>
            <a:xfrm>
              <a:off x="981223" y="4837432"/>
              <a:ext cx="2262530" cy="1852644"/>
              <a:chOff x="4262730" y="1938648"/>
              <a:chExt cx="3254647" cy="2425728"/>
            </a:xfrm>
          </p:grpSpPr>
          <p:sp>
            <p:nvSpPr>
              <p:cNvPr id="11" name="TextBox 10">
                <a:extLst>
                  <a:ext uri="{FF2B5EF4-FFF2-40B4-BE49-F238E27FC236}">
                    <a16:creationId xmlns:a16="http://schemas.microsoft.com/office/drawing/2014/main" id="{AE8A8C31-1407-8E15-488F-4FD271818F32}"/>
                  </a:ext>
                </a:extLst>
              </p:cNvPr>
              <p:cNvSpPr txBox="1"/>
              <p:nvPr/>
            </p:nvSpPr>
            <p:spPr>
              <a:xfrm>
                <a:off x="5686064" y="3390829"/>
                <a:ext cx="514870" cy="336381"/>
              </a:xfrm>
              <a:prstGeom prst="rect">
                <a:avLst/>
              </a:prstGeom>
              <a:noFill/>
            </p:spPr>
            <p:txBody>
              <a:bodyPr wrap="none" rtlCol="0">
                <a:spAutoFit/>
              </a:bodyPr>
              <a:lstStyle/>
              <a:p>
                <a:r>
                  <a:rPr lang="en-US" sz="964" dirty="0"/>
                  <a:t>C4</a:t>
                </a:r>
              </a:p>
            </p:txBody>
          </p:sp>
          <p:sp>
            <p:nvSpPr>
              <p:cNvPr id="15" name="TextBox 14">
                <a:extLst>
                  <a:ext uri="{FF2B5EF4-FFF2-40B4-BE49-F238E27FC236}">
                    <a16:creationId xmlns:a16="http://schemas.microsoft.com/office/drawing/2014/main" id="{256198C0-5DAF-1DFB-77B2-5DCC6D6E8073}"/>
                  </a:ext>
                </a:extLst>
              </p:cNvPr>
              <p:cNvSpPr txBox="1"/>
              <p:nvPr/>
            </p:nvSpPr>
            <p:spPr>
              <a:xfrm>
                <a:off x="5730251" y="1938648"/>
                <a:ext cx="495181" cy="336381"/>
              </a:xfrm>
              <a:prstGeom prst="rect">
                <a:avLst/>
              </a:prstGeom>
              <a:noFill/>
            </p:spPr>
            <p:txBody>
              <a:bodyPr wrap="none" rtlCol="0">
                <a:spAutoFit/>
              </a:bodyPr>
              <a:lstStyle/>
              <a:p>
                <a:r>
                  <a:rPr lang="en-US" sz="964" dirty="0"/>
                  <a:t>P4</a:t>
                </a:r>
              </a:p>
            </p:txBody>
          </p:sp>
          <p:sp>
            <p:nvSpPr>
              <p:cNvPr id="25" name="TextBox 24">
                <a:extLst>
                  <a:ext uri="{FF2B5EF4-FFF2-40B4-BE49-F238E27FC236}">
                    <a16:creationId xmlns:a16="http://schemas.microsoft.com/office/drawing/2014/main" id="{14B19373-B16C-3929-B838-55F651A566CB}"/>
                  </a:ext>
                </a:extLst>
              </p:cNvPr>
              <p:cNvSpPr txBox="1"/>
              <p:nvPr/>
            </p:nvSpPr>
            <p:spPr>
              <a:xfrm>
                <a:off x="4720995" y="3561187"/>
                <a:ext cx="514870" cy="336381"/>
              </a:xfrm>
              <a:prstGeom prst="rect">
                <a:avLst/>
              </a:prstGeom>
              <a:noFill/>
            </p:spPr>
            <p:txBody>
              <a:bodyPr wrap="none" rtlCol="0">
                <a:spAutoFit/>
              </a:bodyPr>
              <a:lstStyle/>
              <a:p>
                <a:r>
                  <a:rPr lang="en-US" sz="964" dirty="0"/>
                  <a:t>C2</a:t>
                </a:r>
              </a:p>
            </p:txBody>
          </p:sp>
          <p:sp>
            <p:nvSpPr>
              <p:cNvPr id="26" name="TextBox 25">
                <a:extLst>
                  <a:ext uri="{FF2B5EF4-FFF2-40B4-BE49-F238E27FC236}">
                    <a16:creationId xmlns:a16="http://schemas.microsoft.com/office/drawing/2014/main" id="{2B3AE73B-902D-30F2-A2B1-E998DCCEB5E9}"/>
                  </a:ext>
                </a:extLst>
              </p:cNvPr>
              <p:cNvSpPr txBox="1"/>
              <p:nvPr/>
            </p:nvSpPr>
            <p:spPr>
              <a:xfrm>
                <a:off x="4262730" y="3292297"/>
                <a:ext cx="514870" cy="336381"/>
              </a:xfrm>
              <a:prstGeom prst="rect">
                <a:avLst/>
              </a:prstGeom>
              <a:noFill/>
            </p:spPr>
            <p:txBody>
              <a:bodyPr wrap="none" rtlCol="0">
                <a:spAutoFit/>
              </a:bodyPr>
              <a:lstStyle/>
              <a:p>
                <a:r>
                  <a:rPr lang="en-US" sz="964" dirty="0"/>
                  <a:t>C1</a:t>
                </a:r>
              </a:p>
            </p:txBody>
          </p:sp>
          <p:sp>
            <p:nvSpPr>
              <p:cNvPr id="28" name="TextBox 27">
                <a:extLst>
                  <a:ext uri="{FF2B5EF4-FFF2-40B4-BE49-F238E27FC236}">
                    <a16:creationId xmlns:a16="http://schemas.microsoft.com/office/drawing/2014/main" id="{F84527E4-B789-D170-A4F8-C7B266E58C9B}"/>
                  </a:ext>
                </a:extLst>
              </p:cNvPr>
              <p:cNvSpPr txBox="1"/>
              <p:nvPr/>
            </p:nvSpPr>
            <p:spPr>
              <a:xfrm>
                <a:off x="4604634" y="3912495"/>
                <a:ext cx="514870" cy="336381"/>
              </a:xfrm>
              <a:prstGeom prst="rect">
                <a:avLst/>
              </a:prstGeom>
              <a:noFill/>
            </p:spPr>
            <p:txBody>
              <a:bodyPr wrap="none" rtlCol="0">
                <a:spAutoFit/>
              </a:bodyPr>
              <a:lstStyle/>
              <a:p>
                <a:r>
                  <a:rPr lang="en-US" sz="964" dirty="0"/>
                  <a:t>C3</a:t>
                </a:r>
              </a:p>
            </p:txBody>
          </p:sp>
          <p:sp>
            <p:nvSpPr>
              <p:cNvPr id="31" name="TextBox 30">
                <a:extLst>
                  <a:ext uri="{FF2B5EF4-FFF2-40B4-BE49-F238E27FC236}">
                    <a16:creationId xmlns:a16="http://schemas.microsoft.com/office/drawing/2014/main" id="{EE75090C-BA9B-CD1B-91AF-BDDCD56FE6E3}"/>
                  </a:ext>
                </a:extLst>
              </p:cNvPr>
              <p:cNvSpPr txBox="1"/>
              <p:nvPr/>
            </p:nvSpPr>
            <p:spPr>
              <a:xfrm>
                <a:off x="6586443" y="2877036"/>
                <a:ext cx="495181" cy="336381"/>
              </a:xfrm>
              <a:prstGeom prst="rect">
                <a:avLst/>
              </a:prstGeom>
              <a:noFill/>
            </p:spPr>
            <p:txBody>
              <a:bodyPr wrap="none" rtlCol="0">
                <a:spAutoFit/>
              </a:bodyPr>
              <a:lstStyle/>
              <a:p>
                <a:r>
                  <a:rPr lang="en-US" sz="964" dirty="0"/>
                  <a:t>P2</a:t>
                </a:r>
              </a:p>
            </p:txBody>
          </p:sp>
          <p:sp>
            <p:nvSpPr>
              <p:cNvPr id="32" name="TextBox 31">
                <a:extLst>
                  <a:ext uri="{FF2B5EF4-FFF2-40B4-BE49-F238E27FC236}">
                    <a16:creationId xmlns:a16="http://schemas.microsoft.com/office/drawing/2014/main" id="{9F575B27-3E15-0556-DA86-C2C28B4B597B}"/>
                  </a:ext>
                </a:extLst>
              </p:cNvPr>
              <p:cNvSpPr txBox="1"/>
              <p:nvPr/>
            </p:nvSpPr>
            <p:spPr>
              <a:xfrm>
                <a:off x="6249303" y="3228728"/>
                <a:ext cx="529763" cy="336381"/>
              </a:xfrm>
              <a:prstGeom prst="rect">
                <a:avLst/>
              </a:prstGeom>
              <a:noFill/>
            </p:spPr>
            <p:txBody>
              <a:bodyPr wrap="square" rtlCol="0">
                <a:spAutoFit/>
              </a:bodyPr>
              <a:lstStyle/>
              <a:p>
                <a:r>
                  <a:rPr lang="en-US" sz="964" dirty="0"/>
                  <a:t>P3</a:t>
                </a:r>
              </a:p>
            </p:txBody>
          </p:sp>
          <p:sp>
            <p:nvSpPr>
              <p:cNvPr id="33" name="TextBox 32">
                <a:extLst>
                  <a:ext uri="{FF2B5EF4-FFF2-40B4-BE49-F238E27FC236}">
                    <a16:creationId xmlns:a16="http://schemas.microsoft.com/office/drawing/2014/main" id="{2AD77E41-4464-17BA-64F2-E64D10787CEE}"/>
                  </a:ext>
                </a:extLst>
              </p:cNvPr>
              <p:cNvSpPr txBox="1"/>
              <p:nvPr/>
            </p:nvSpPr>
            <p:spPr>
              <a:xfrm>
                <a:off x="7022196" y="4027995"/>
                <a:ext cx="495181" cy="336381"/>
              </a:xfrm>
              <a:prstGeom prst="rect">
                <a:avLst/>
              </a:prstGeom>
              <a:noFill/>
            </p:spPr>
            <p:txBody>
              <a:bodyPr wrap="none" rtlCol="0">
                <a:spAutoFit/>
              </a:bodyPr>
              <a:lstStyle/>
              <a:p>
                <a:r>
                  <a:rPr lang="en-US" sz="964" dirty="0"/>
                  <a:t>P1</a:t>
                </a:r>
              </a:p>
            </p:txBody>
          </p:sp>
        </p:grpSp>
      </p:grpSp>
      <p:sp>
        <p:nvSpPr>
          <p:cNvPr id="3" name="TextBox 2">
            <a:extLst>
              <a:ext uri="{FF2B5EF4-FFF2-40B4-BE49-F238E27FC236}">
                <a16:creationId xmlns:a16="http://schemas.microsoft.com/office/drawing/2014/main" id="{CD28AE99-020E-2577-22DB-6FA2F17B9A8F}"/>
              </a:ext>
            </a:extLst>
          </p:cNvPr>
          <p:cNvSpPr txBox="1"/>
          <p:nvPr/>
        </p:nvSpPr>
        <p:spPr>
          <a:xfrm>
            <a:off x="157672" y="124823"/>
            <a:ext cx="3488786" cy="307777"/>
          </a:xfrm>
          <a:prstGeom prst="rect">
            <a:avLst/>
          </a:prstGeom>
          <a:noFill/>
        </p:spPr>
        <p:txBody>
          <a:bodyPr wrap="square">
            <a:spAutoFit/>
          </a:bodyPr>
          <a:lstStyle/>
          <a:p>
            <a:r>
              <a:rPr lang="en-US" sz="1400" b="1" dirty="0">
                <a:latin typeface="Arial" panose="020B0604020202020204" pitchFamily="34" charset="0"/>
                <a:ea typeface="Times New Roman" panose="02020603050405020304" pitchFamily="18" charset="0"/>
                <a:cs typeface="Arial" panose="020B0604020202020204" pitchFamily="34" charset="0"/>
              </a:rPr>
              <a:t>Supplemental Figure 5</a:t>
            </a:r>
            <a:endParaRPr lang="en-US" sz="1400" dirty="0"/>
          </a:p>
        </p:txBody>
      </p:sp>
    </p:spTree>
    <p:extLst>
      <p:ext uri="{BB962C8B-B14F-4D97-AF65-F5344CB8AC3E}">
        <p14:creationId xmlns:p14="http://schemas.microsoft.com/office/powerpoint/2010/main" val="30634969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4</TotalTime>
  <Words>126</Words>
  <Application>Microsoft Macintosh PowerPoint</Application>
  <PresentationFormat>Letter Paper (8.5x11 in)</PresentationFormat>
  <Paragraphs>2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harlie Schurman</dc:creator>
  <cp:lastModifiedBy>Birgit Schilling</cp:lastModifiedBy>
  <cp:revision>18</cp:revision>
  <dcterms:created xsi:type="dcterms:W3CDTF">2024-10-28T17:59:57Z</dcterms:created>
  <dcterms:modified xsi:type="dcterms:W3CDTF">2025-01-22T03:32:50Z</dcterms:modified>
</cp:coreProperties>
</file>